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handoutMasterIdLst>
    <p:handoutMasterId r:id="rId17"/>
  </p:handoutMasterIdLst>
  <p:sldIdLst>
    <p:sldId id="398" r:id="rId2"/>
    <p:sldId id="400" r:id="rId3"/>
    <p:sldId id="399" r:id="rId4"/>
    <p:sldId id="377" r:id="rId5"/>
    <p:sldId id="389" r:id="rId6"/>
    <p:sldId id="376" r:id="rId7"/>
    <p:sldId id="390" r:id="rId8"/>
    <p:sldId id="401" r:id="rId9"/>
    <p:sldId id="348" r:id="rId10"/>
    <p:sldId id="392" r:id="rId11"/>
    <p:sldId id="379" r:id="rId12"/>
    <p:sldId id="367" r:id="rId13"/>
    <p:sldId id="370" r:id="rId14"/>
    <p:sldId id="393" r:id="rId15"/>
  </p:sldIdLst>
  <p:sldSz cx="9144000" cy="6858000" type="screen4x3"/>
  <p:notesSz cx="9945688" cy="6858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53" userDrawn="1">
          <p15:clr>
            <a:srgbClr val="A4A3A4"/>
          </p15:clr>
        </p15:guide>
        <p15:guide id="2" pos="1814" userDrawn="1">
          <p15:clr>
            <a:srgbClr val="A4A3A4"/>
          </p15:clr>
        </p15:guide>
        <p15:guide id="3" pos="2812" userDrawn="1">
          <p15:clr>
            <a:srgbClr val="A4A3A4"/>
          </p15:clr>
        </p15:guide>
        <p15:guide id="4" orient="horz" pos="32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83" autoAdjust="0"/>
    <p:restoredTop sz="94660"/>
  </p:normalViewPr>
  <p:slideViewPr>
    <p:cSldViewPr snapToGrid="0" showGuides="1">
      <p:cViewPr varScale="1">
        <p:scale>
          <a:sx n="93" d="100"/>
          <a:sy n="93" d="100"/>
        </p:scale>
        <p:origin x="648" y="78"/>
      </p:cViewPr>
      <p:guideLst>
        <p:guide orient="horz" pos="1253"/>
        <p:guide pos="1814"/>
        <p:guide pos="2812"/>
        <p:guide orient="horz" pos="322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3" y="2"/>
            <a:ext cx="4309798" cy="343721"/>
          </a:xfrm>
          <a:prstGeom prst="rect">
            <a:avLst/>
          </a:prstGeom>
        </p:spPr>
        <p:txBody>
          <a:bodyPr vert="horz" lIns="91416" tIns="45709" rIns="91416" bIns="45709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33588" y="2"/>
            <a:ext cx="4309798" cy="343721"/>
          </a:xfrm>
          <a:prstGeom prst="rect">
            <a:avLst/>
          </a:prstGeom>
        </p:spPr>
        <p:txBody>
          <a:bodyPr vert="horz" lIns="91416" tIns="45709" rIns="91416" bIns="45709" rtlCol="0"/>
          <a:lstStyle>
            <a:lvl1pPr algn="r">
              <a:defRPr sz="1200"/>
            </a:lvl1pPr>
          </a:lstStyle>
          <a:p>
            <a:fld id="{546F5850-A421-4858-B9F1-03A68CFB6AB8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3" y="6514282"/>
            <a:ext cx="4309798" cy="343721"/>
          </a:xfrm>
          <a:prstGeom prst="rect">
            <a:avLst/>
          </a:prstGeom>
        </p:spPr>
        <p:txBody>
          <a:bodyPr vert="horz" lIns="91416" tIns="45709" rIns="91416" bIns="45709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33588" y="6514282"/>
            <a:ext cx="4309798" cy="343721"/>
          </a:xfrm>
          <a:prstGeom prst="rect">
            <a:avLst/>
          </a:prstGeom>
        </p:spPr>
        <p:txBody>
          <a:bodyPr vert="horz" lIns="91416" tIns="45709" rIns="91416" bIns="45709" rtlCol="0" anchor="b"/>
          <a:lstStyle>
            <a:lvl1pPr algn="r">
              <a:defRPr sz="1200"/>
            </a:lvl1pPr>
          </a:lstStyle>
          <a:p>
            <a:fld id="{E9707074-1113-46DD-BFAD-F84D54906E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66905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3" y="3"/>
            <a:ext cx="4309798" cy="344091"/>
          </a:xfrm>
          <a:prstGeom prst="rect">
            <a:avLst/>
          </a:prstGeom>
        </p:spPr>
        <p:txBody>
          <a:bodyPr vert="horz" lIns="91847" tIns="45924" rIns="91847" bIns="45924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33590" y="3"/>
            <a:ext cx="4309798" cy="344091"/>
          </a:xfrm>
          <a:prstGeom prst="rect">
            <a:avLst/>
          </a:prstGeom>
        </p:spPr>
        <p:txBody>
          <a:bodyPr vert="horz" lIns="91847" tIns="45924" rIns="91847" bIns="45924" rtlCol="0"/>
          <a:lstStyle>
            <a:lvl1pPr algn="r">
              <a:defRPr sz="1200"/>
            </a:lvl1pPr>
          </a:lstStyle>
          <a:p>
            <a:fld id="{E37DF175-2700-48D2-801D-F13329ECBE82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430588" y="858838"/>
            <a:ext cx="3084512" cy="2312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47" tIns="45924" rIns="91847" bIns="4592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4570" y="3300414"/>
            <a:ext cx="7956550" cy="2700338"/>
          </a:xfrm>
          <a:prstGeom prst="rect">
            <a:avLst/>
          </a:prstGeom>
        </p:spPr>
        <p:txBody>
          <a:bodyPr vert="horz" lIns="91847" tIns="45924" rIns="91847" bIns="4592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3" y="6513912"/>
            <a:ext cx="4309798" cy="344091"/>
          </a:xfrm>
          <a:prstGeom prst="rect">
            <a:avLst/>
          </a:prstGeom>
        </p:spPr>
        <p:txBody>
          <a:bodyPr vert="horz" lIns="91847" tIns="45924" rIns="91847" bIns="45924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33590" y="6513912"/>
            <a:ext cx="4309798" cy="344091"/>
          </a:xfrm>
          <a:prstGeom prst="rect">
            <a:avLst/>
          </a:prstGeom>
        </p:spPr>
        <p:txBody>
          <a:bodyPr vert="horz" lIns="91847" tIns="45924" rIns="91847" bIns="45924" rtlCol="0" anchor="b"/>
          <a:lstStyle>
            <a:lvl1pPr algn="r">
              <a:defRPr sz="1200"/>
            </a:lvl1pPr>
          </a:lstStyle>
          <a:p>
            <a:fld id="{54300319-9F0C-46B6-A75E-EAC079DE2D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59979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2882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0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9783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8572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0595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676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9866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484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2067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2449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928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3792F-D2FE-4EEC-BEEF-541B9CAD4E86}" type="datetimeFigureOut">
              <a:rPr lang="ko-KR" altLang="en-US" smtClean="0"/>
              <a:t>2017-05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2505F8-EE20-47AD-AB23-8FD8A0A31D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8236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3.em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l="12149" r="3556"/>
          <a:stretch/>
        </p:blipFill>
        <p:spPr>
          <a:xfrm>
            <a:off x="1405584" y="341450"/>
            <a:ext cx="7286463" cy="6408000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6422881" y="1618757"/>
            <a:ext cx="228360" cy="5608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/>
          <p:cNvSpPr txBox="1"/>
          <p:nvPr/>
        </p:nvSpPr>
        <p:spPr>
          <a:xfrm>
            <a:off x="4806373" y="797342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950533" y="797342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094694" y="797342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그룹 24"/>
          <p:cNvGrpSpPr/>
          <p:nvPr/>
        </p:nvGrpSpPr>
        <p:grpSpPr>
          <a:xfrm>
            <a:off x="157290" y="281178"/>
            <a:ext cx="1332416" cy="645626"/>
            <a:chOff x="-110718" y="281178"/>
            <a:chExt cx="1332416" cy="645626"/>
          </a:xfrm>
        </p:grpSpPr>
        <p:sp>
          <p:nvSpPr>
            <p:cNvPr id="8" name="TextBox 7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3" name="그룹 102"/>
          <p:cNvGrpSpPr/>
          <p:nvPr/>
        </p:nvGrpSpPr>
        <p:grpSpPr>
          <a:xfrm>
            <a:off x="8644120" y="278168"/>
            <a:ext cx="325730" cy="645626"/>
            <a:chOff x="8644120" y="383269"/>
            <a:chExt cx="325730" cy="645626"/>
          </a:xfrm>
        </p:grpSpPr>
        <p:sp>
          <p:nvSpPr>
            <p:cNvPr id="16" name="TextBox 15"/>
            <p:cNvSpPr txBox="1"/>
            <p:nvPr/>
          </p:nvSpPr>
          <p:spPr>
            <a:xfrm>
              <a:off x="8644120" y="38326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7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644120" y="51640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7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644120" y="64953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644120" y="78267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그룹 103"/>
          <p:cNvGrpSpPr/>
          <p:nvPr/>
        </p:nvGrpSpPr>
        <p:grpSpPr>
          <a:xfrm>
            <a:off x="8644120" y="927330"/>
            <a:ext cx="396262" cy="645626"/>
            <a:chOff x="9045551" y="955458"/>
            <a:chExt cx="396262" cy="645626"/>
          </a:xfrm>
        </p:grpSpPr>
        <p:sp>
          <p:nvSpPr>
            <p:cNvPr id="20" name="TextBox 19"/>
            <p:cNvSpPr txBox="1"/>
            <p:nvPr/>
          </p:nvSpPr>
          <p:spPr>
            <a:xfrm>
              <a:off x="9045551" y="95545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7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045551" y="108859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1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045551" y="122172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9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045551" y="135486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3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그룹 25"/>
          <p:cNvGrpSpPr/>
          <p:nvPr/>
        </p:nvGrpSpPr>
        <p:grpSpPr>
          <a:xfrm>
            <a:off x="157290" y="931066"/>
            <a:ext cx="1332416" cy="645626"/>
            <a:chOff x="-110718" y="281178"/>
            <a:chExt cx="1332416" cy="645626"/>
          </a:xfrm>
        </p:grpSpPr>
        <p:sp>
          <p:nvSpPr>
            <p:cNvPr id="27" name="TextBox 26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그룹 30"/>
          <p:cNvGrpSpPr/>
          <p:nvPr/>
        </p:nvGrpSpPr>
        <p:grpSpPr>
          <a:xfrm>
            <a:off x="157290" y="1580954"/>
            <a:ext cx="1332416" cy="645626"/>
            <a:chOff x="-110718" y="281178"/>
            <a:chExt cx="1332416" cy="645626"/>
          </a:xfrm>
        </p:grpSpPr>
        <p:sp>
          <p:nvSpPr>
            <p:cNvPr id="32" name="TextBox 31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그룹 35"/>
          <p:cNvGrpSpPr/>
          <p:nvPr/>
        </p:nvGrpSpPr>
        <p:grpSpPr>
          <a:xfrm>
            <a:off x="157290" y="2230842"/>
            <a:ext cx="1332416" cy="645626"/>
            <a:chOff x="-110718" y="281178"/>
            <a:chExt cx="1332416" cy="645626"/>
          </a:xfrm>
        </p:grpSpPr>
        <p:sp>
          <p:nvSpPr>
            <p:cNvPr id="37" name="TextBox 36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그룹 40"/>
          <p:cNvGrpSpPr/>
          <p:nvPr/>
        </p:nvGrpSpPr>
        <p:grpSpPr>
          <a:xfrm>
            <a:off x="157290" y="2880730"/>
            <a:ext cx="1332416" cy="645626"/>
            <a:chOff x="-110718" y="281178"/>
            <a:chExt cx="1332416" cy="645626"/>
          </a:xfrm>
        </p:grpSpPr>
        <p:sp>
          <p:nvSpPr>
            <p:cNvPr id="42" name="TextBox 41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그룹 45"/>
          <p:cNvGrpSpPr/>
          <p:nvPr/>
        </p:nvGrpSpPr>
        <p:grpSpPr>
          <a:xfrm>
            <a:off x="157290" y="3530618"/>
            <a:ext cx="1332416" cy="645626"/>
            <a:chOff x="-110718" y="281178"/>
            <a:chExt cx="1332416" cy="645626"/>
          </a:xfrm>
        </p:grpSpPr>
        <p:sp>
          <p:nvSpPr>
            <p:cNvPr id="47" name="TextBox 46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그룹 50"/>
          <p:cNvGrpSpPr/>
          <p:nvPr/>
        </p:nvGrpSpPr>
        <p:grpSpPr>
          <a:xfrm>
            <a:off x="157290" y="4180506"/>
            <a:ext cx="1332416" cy="645626"/>
            <a:chOff x="-110718" y="281178"/>
            <a:chExt cx="1332416" cy="645626"/>
          </a:xfrm>
        </p:grpSpPr>
        <p:sp>
          <p:nvSpPr>
            <p:cNvPr id="52" name="TextBox 51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그룹 55"/>
          <p:cNvGrpSpPr/>
          <p:nvPr/>
        </p:nvGrpSpPr>
        <p:grpSpPr>
          <a:xfrm>
            <a:off x="157290" y="4830394"/>
            <a:ext cx="1332416" cy="645626"/>
            <a:chOff x="-110718" y="281178"/>
            <a:chExt cx="1332416" cy="645626"/>
          </a:xfrm>
        </p:grpSpPr>
        <p:sp>
          <p:nvSpPr>
            <p:cNvPr id="57" name="TextBox 56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그룹 60"/>
          <p:cNvGrpSpPr/>
          <p:nvPr/>
        </p:nvGrpSpPr>
        <p:grpSpPr>
          <a:xfrm>
            <a:off x="157290" y="5480282"/>
            <a:ext cx="1332416" cy="645626"/>
            <a:chOff x="-110718" y="281178"/>
            <a:chExt cx="1332416" cy="645626"/>
          </a:xfrm>
        </p:grpSpPr>
        <p:sp>
          <p:nvSpPr>
            <p:cNvPr id="62" name="TextBox 61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그룹 65"/>
          <p:cNvGrpSpPr/>
          <p:nvPr/>
        </p:nvGrpSpPr>
        <p:grpSpPr>
          <a:xfrm>
            <a:off x="157290" y="6130167"/>
            <a:ext cx="1332416" cy="645626"/>
            <a:chOff x="-110718" y="281178"/>
            <a:chExt cx="1332416" cy="645626"/>
          </a:xfrm>
        </p:grpSpPr>
        <p:sp>
          <p:nvSpPr>
            <p:cNvPr id="67" name="TextBox 66"/>
            <p:cNvSpPr txBox="1"/>
            <p:nvPr/>
          </p:nvSpPr>
          <p:spPr>
            <a:xfrm>
              <a:off x="-110718" y="281178"/>
              <a:ext cx="13324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94841" y="414313"/>
              <a:ext cx="9268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99037" y="547448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7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99037" y="68058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4g1278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그룹 104"/>
          <p:cNvGrpSpPr/>
          <p:nvPr/>
        </p:nvGrpSpPr>
        <p:grpSpPr>
          <a:xfrm>
            <a:off x="8644120" y="1576492"/>
            <a:ext cx="396262" cy="645626"/>
            <a:chOff x="9078978" y="1588129"/>
            <a:chExt cx="396262" cy="645626"/>
          </a:xfrm>
        </p:grpSpPr>
        <p:sp>
          <p:nvSpPr>
            <p:cNvPr id="71" name="TextBox 70"/>
            <p:cNvSpPr txBox="1"/>
            <p:nvPr/>
          </p:nvSpPr>
          <p:spPr>
            <a:xfrm>
              <a:off x="9078978" y="158812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9078978" y="172126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9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9078978" y="185439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9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9078978" y="198753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6" name="그룹 105"/>
          <p:cNvGrpSpPr/>
          <p:nvPr/>
        </p:nvGrpSpPr>
        <p:grpSpPr>
          <a:xfrm>
            <a:off x="8644120" y="2225654"/>
            <a:ext cx="396262" cy="645626"/>
            <a:chOff x="9045551" y="2230842"/>
            <a:chExt cx="396262" cy="645626"/>
          </a:xfrm>
        </p:grpSpPr>
        <p:sp>
          <p:nvSpPr>
            <p:cNvPr id="75" name="TextBox 74"/>
            <p:cNvSpPr txBox="1"/>
            <p:nvPr/>
          </p:nvSpPr>
          <p:spPr>
            <a:xfrm>
              <a:off x="9045551" y="223084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9045551" y="236397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7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9045551" y="249711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9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9045551" y="263024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1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7" name="그룹 106"/>
          <p:cNvGrpSpPr/>
          <p:nvPr/>
        </p:nvGrpSpPr>
        <p:grpSpPr>
          <a:xfrm>
            <a:off x="8644120" y="2874816"/>
            <a:ext cx="396262" cy="645626"/>
            <a:chOff x="9078978" y="2897105"/>
            <a:chExt cx="396262" cy="645626"/>
          </a:xfrm>
        </p:grpSpPr>
        <p:sp>
          <p:nvSpPr>
            <p:cNvPr id="79" name="TextBox 78"/>
            <p:cNvSpPr txBox="1"/>
            <p:nvPr/>
          </p:nvSpPr>
          <p:spPr>
            <a:xfrm>
              <a:off x="9078978" y="289710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4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9078978" y="303024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75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9078978" y="316337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9078978" y="329651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2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그룹 107"/>
          <p:cNvGrpSpPr/>
          <p:nvPr/>
        </p:nvGrpSpPr>
        <p:grpSpPr>
          <a:xfrm>
            <a:off x="8644120" y="3523978"/>
            <a:ext cx="396262" cy="645626"/>
            <a:chOff x="9381305" y="3570562"/>
            <a:chExt cx="396262" cy="645626"/>
          </a:xfrm>
        </p:grpSpPr>
        <p:sp>
          <p:nvSpPr>
            <p:cNvPr id="83" name="TextBox 82"/>
            <p:cNvSpPr txBox="1"/>
            <p:nvPr/>
          </p:nvSpPr>
          <p:spPr>
            <a:xfrm>
              <a:off x="9381305" y="357056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4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9381305" y="370369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4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9381305" y="383683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7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9381305" y="396996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9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그룹 108"/>
          <p:cNvGrpSpPr/>
          <p:nvPr/>
        </p:nvGrpSpPr>
        <p:grpSpPr>
          <a:xfrm>
            <a:off x="8644120" y="4173140"/>
            <a:ext cx="396262" cy="645626"/>
            <a:chOff x="9078978" y="4180506"/>
            <a:chExt cx="396262" cy="645626"/>
          </a:xfrm>
        </p:grpSpPr>
        <p:sp>
          <p:nvSpPr>
            <p:cNvPr id="87" name="TextBox 86"/>
            <p:cNvSpPr txBox="1"/>
            <p:nvPr/>
          </p:nvSpPr>
          <p:spPr>
            <a:xfrm>
              <a:off x="9078978" y="4180506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3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9078978" y="431364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9078978" y="4446776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15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9078978" y="457991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28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0" name="그룹 109"/>
          <p:cNvGrpSpPr/>
          <p:nvPr/>
        </p:nvGrpSpPr>
        <p:grpSpPr>
          <a:xfrm>
            <a:off x="8644120" y="4822302"/>
            <a:ext cx="396262" cy="645626"/>
            <a:chOff x="9183174" y="4870045"/>
            <a:chExt cx="396262" cy="645626"/>
          </a:xfrm>
        </p:grpSpPr>
        <p:sp>
          <p:nvSpPr>
            <p:cNvPr id="91" name="TextBox 90"/>
            <p:cNvSpPr txBox="1"/>
            <p:nvPr/>
          </p:nvSpPr>
          <p:spPr>
            <a:xfrm>
              <a:off x="9183174" y="487004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3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9183174" y="500318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94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9183174" y="513631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93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9183174" y="526945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1" name="그룹 110"/>
          <p:cNvGrpSpPr/>
          <p:nvPr/>
        </p:nvGrpSpPr>
        <p:grpSpPr>
          <a:xfrm>
            <a:off x="8644120" y="5471464"/>
            <a:ext cx="396262" cy="645626"/>
            <a:chOff x="9243682" y="5546019"/>
            <a:chExt cx="396262" cy="645626"/>
          </a:xfrm>
        </p:grpSpPr>
        <p:sp>
          <p:nvSpPr>
            <p:cNvPr id="95" name="TextBox 94"/>
            <p:cNvSpPr txBox="1"/>
            <p:nvPr/>
          </p:nvSpPr>
          <p:spPr>
            <a:xfrm>
              <a:off x="9243682" y="554601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27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9243682" y="567915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90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9243682" y="581228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93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9243682" y="594542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6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2" name="그룹 111"/>
          <p:cNvGrpSpPr/>
          <p:nvPr/>
        </p:nvGrpSpPr>
        <p:grpSpPr>
          <a:xfrm>
            <a:off x="8644120" y="6120628"/>
            <a:ext cx="396262" cy="645626"/>
            <a:chOff x="9579436" y="6110118"/>
            <a:chExt cx="396262" cy="645626"/>
          </a:xfrm>
        </p:grpSpPr>
        <p:sp>
          <p:nvSpPr>
            <p:cNvPr id="99" name="TextBox 98"/>
            <p:cNvSpPr txBox="1"/>
            <p:nvPr/>
          </p:nvSpPr>
          <p:spPr>
            <a:xfrm>
              <a:off x="9579436" y="611011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25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9579436" y="624325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88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9579436" y="637638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91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9579436" y="650952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4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3" name="직선 연결선 12"/>
          <p:cNvCxnSpPr/>
          <p:nvPr/>
        </p:nvCxnSpPr>
        <p:spPr>
          <a:xfrm>
            <a:off x="2091352" y="6767108"/>
            <a:ext cx="6444000" cy="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1</a:t>
            </a:r>
            <a:endParaRPr lang="ko-KR" altLang="en-US" sz="1200" dirty="0"/>
          </a:p>
        </p:txBody>
      </p:sp>
      <p:cxnSp>
        <p:nvCxnSpPr>
          <p:cNvPr id="115" name="직선 연결선 114"/>
          <p:cNvCxnSpPr/>
          <p:nvPr/>
        </p:nvCxnSpPr>
        <p:spPr>
          <a:xfrm>
            <a:off x="5769819" y="6165128"/>
            <a:ext cx="23717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2390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 rot="16200000">
            <a:off x="-727234" y="2362073"/>
            <a:ext cx="1815123" cy="299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8709" y="415884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8709" y="337863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3739" y="259842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3739" y="181820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3739" y="103799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3739" y="25778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8</a:t>
            </a:r>
            <a:endParaRPr lang="ko-KR" altLang="en-US" sz="1200" dirty="0"/>
          </a:p>
        </p:txBody>
      </p:sp>
      <p:pic>
        <p:nvPicPr>
          <p:cNvPr id="2" name="그림 1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86187" y="412130"/>
            <a:ext cx="8409600" cy="3909600"/>
          </a:xfrm>
          <a:prstGeom prst="rect">
            <a:avLst/>
          </a:prstGeom>
        </p:spPr>
      </p:pic>
      <p:sp>
        <p:nvSpPr>
          <p:cNvPr id="97" name="TextBox 96"/>
          <p:cNvSpPr txBox="1"/>
          <p:nvPr/>
        </p:nvSpPr>
        <p:spPr>
          <a:xfrm>
            <a:off x="1348456" y="359545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2080869" y="302760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4205558" y="3321779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8" name="그룹 207"/>
          <p:cNvGrpSpPr/>
          <p:nvPr/>
        </p:nvGrpSpPr>
        <p:grpSpPr>
          <a:xfrm>
            <a:off x="1176572" y="3860247"/>
            <a:ext cx="614304" cy="49106"/>
            <a:chOff x="5206111" y="592667"/>
            <a:chExt cx="1593343" cy="778991"/>
          </a:xfrm>
        </p:grpSpPr>
        <p:cxnSp>
          <p:nvCxnSpPr>
            <p:cNvPr id="209" name="직선 연결선 208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직선 연결선 20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직선 연결선 21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2" name="그룹 211"/>
          <p:cNvGrpSpPr/>
          <p:nvPr/>
        </p:nvGrpSpPr>
        <p:grpSpPr>
          <a:xfrm>
            <a:off x="3129171" y="3951003"/>
            <a:ext cx="260525" cy="49106"/>
            <a:chOff x="5206111" y="592667"/>
            <a:chExt cx="1593343" cy="778991"/>
          </a:xfrm>
        </p:grpSpPr>
        <p:cxnSp>
          <p:nvCxnSpPr>
            <p:cNvPr id="213" name="직선 연결선 21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직선 연결선 213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직선 연결선 214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6" name="그룹 215"/>
          <p:cNvGrpSpPr/>
          <p:nvPr/>
        </p:nvGrpSpPr>
        <p:grpSpPr>
          <a:xfrm>
            <a:off x="4587568" y="3907486"/>
            <a:ext cx="381436" cy="49106"/>
            <a:chOff x="5206111" y="592667"/>
            <a:chExt cx="1593343" cy="778991"/>
          </a:xfrm>
        </p:grpSpPr>
        <p:cxnSp>
          <p:nvCxnSpPr>
            <p:cNvPr id="217" name="직선 연결선 216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직선 연결선 217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직선 연결선 218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0" name="그룹 219"/>
          <p:cNvGrpSpPr/>
          <p:nvPr/>
        </p:nvGrpSpPr>
        <p:grpSpPr>
          <a:xfrm>
            <a:off x="6567568" y="3422893"/>
            <a:ext cx="260525" cy="49106"/>
            <a:chOff x="5206111" y="592667"/>
            <a:chExt cx="1593343" cy="778991"/>
          </a:xfrm>
        </p:grpSpPr>
        <p:cxnSp>
          <p:nvCxnSpPr>
            <p:cNvPr id="221" name="직선 연결선 22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직선 연결선 22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직선 연결선 22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4" name="그룹 223"/>
          <p:cNvGrpSpPr/>
          <p:nvPr/>
        </p:nvGrpSpPr>
        <p:grpSpPr>
          <a:xfrm>
            <a:off x="2755993" y="3233172"/>
            <a:ext cx="236841" cy="49106"/>
            <a:chOff x="5206111" y="592667"/>
            <a:chExt cx="1593343" cy="778991"/>
          </a:xfrm>
        </p:grpSpPr>
        <p:cxnSp>
          <p:nvCxnSpPr>
            <p:cNvPr id="225" name="직선 연결선 22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직선 연결선 22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직선 연결선 226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8" name="TextBox 227"/>
          <p:cNvSpPr txBox="1"/>
          <p:nvPr/>
        </p:nvSpPr>
        <p:spPr>
          <a:xfrm>
            <a:off x="3145444" y="368613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4654030" y="365289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6520822" y="316829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1" name="그룹 230"/>
          <p:cNvGrpSpPr/>
          <p:nvPr/>
        </p:nvGrpSpPr>
        <p:grpSpPr>
          <a:xfrm>
            <a:off x="3405122" y="3540983"/>
            <a:ext cx="899407" cy="49106"/>
            <a:chOff x="5206111" y="592667"/>
            <a:chExt cx="1593343" cy="778991"/>
          </a:xfrm>
        </p:grpSpPr>
        <p:cxnSp>
          <p:nvCxnSpPr>
            <p:cNvPr id="232" name="직선 연결선 231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직선 연결선 232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직선 연결선 233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5" name="TextBox 234"/>
          <p:cNvSpPr txBox="1"/>
          <p:nvPr/>
        </p:nvSpPr>
        <p:spPr>
          <a:xfrm>
            <a:off x="3673153" y="328435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5325442" y="268294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7" name="그룹 236"/>
          <p:cNvGrpSpPr/>
          <p:nvPr/>
        </p:nvGrpSpPr>
        <p:grpSpPr>
          <a:xfrm>
            <a:off x="4989810" y="2939882"/>
            <a:ext cx="899407" cy="49106"/>
            <a:chOff x="5206111" y="592667"/>
            <a:chExt cx="1593343" cy="778991"/>
          </a:xfrm>
        </p:grpSpPr>
        <p:cxnSp>
          <p:nvCxnSpPr>
            <p:cNvPr id="238" name="직선 연결선 23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직선 연결선 23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직선 연결선 23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1" name="TextBox 240"/>
          <p:cNvSpPr txBox="1"/>
          <p:nvPr/>
        </p:nvSpPr>
        <p:spPr>
          <a:xfrm rot="16200000">
            <a:off x="7336394" y="322756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2" name="그룹 241"/>
          <p:cNvGrpSpPr/>
          <p:nvPr/>
        </p:nvGrpSpPr>
        <p:grpSpPr>
          <a:xfrm>
            <a:off x="6845342" y="3299593"/>
            <a:ext cx="614307" cy="49106"/>
            <a:chOff x="5206111" y="592667"/>
            <a:chExt cx="1593343" cy="778991"/>
          </a:xfrm>
        </p:grpSpPr>
        <p:cxnSp>
          <p:nvCxnSpPr>
            <p:cNvPr id="243" name="직선 연결선 24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직선 연결선 243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직선 연결선 244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0" name="TextBox 249"/>
          <p:cNvSpPr txBox="1"/>
          <p:nvPr/>
        </p:nvSpPr>
        <p:spPr>
          <a:xfrm>
            <a:off x="6998251" y="299322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7840199" y="52076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3" name="그룹 252"/>
          <p:cNvGrpSpPr/>
          <p:nvPr/>
        </p:nvGrpSpPr>
        <p:grpSpPr>
          <a:xfrm>
            <a:off x="7724397" y="779594"/>
            <a:ext cx="461535" cy="49106"/>
            <a:chOff x="5206111" y="592667"/>
            <a:chExt cx="1593343" cy="778991"/>
          </a:xfrm>
        </p:grpSpPr>
        <p:cxnSp>
          <p:nvCxnSpPr>
            <p:cNvPr id="254" name="직선 연결선 253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직선 연결선 254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직선 연결선 255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7" name="TextBox 256"/>
          <p:cNvSpPr txBox="1"/>
          <p:nvPr/>
        </p:nvSpPr>
        <p:spPr>
          <a:xfrm>
            <a:off x="8328191" y="302383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8" name="그룹 257"/>
          <p:cNvGrpSpPr/>
          <p:nvPr/>
        </p:nvGrpSpPr>
        <p:grpSpPr>
          <a:xfrm>
            <a:off x="8280656" y="3282670"/>
            <a:ext cx="419577" cy="49106"/>
            <a:chOff x="5206111" y="592667"/>
            <a:chExt cx="1593343" cy="778991"/>
          </a:xfrm>
        </p:grpSpPr>
        <p:cxnSp>
          <p:nvCxnSpPr>
            <p:cNvPr id="259" name="직선 연결선 258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직선 연결선 25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직선 연결선 26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3" name="TextBox 132"/>
          <p:cNvSpPr txBox="1"/>
          <p:nvPr/>
        </p:nvSpPr>
        <p:spPr>
          <a:xfrm rot="16200000">
            <a:off x="1755683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 rot="16200000">
            <a:off x="1094343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 rot="16200000">
            <a:off x="2681559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1226611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1887951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 rot="16200000">
            <a:off x="2813822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 rot="16200000">
            <a:off x="1358879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 rot="16200000">
            <a:off x="2020219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 rot="16200000">
            <a:off x="2152487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 rot="16200000">
            <a:off x="2249489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 rot="16200000">
            <a:off x="1455881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 rot="16200000">
            <a:off x="2381757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 rot="16200000">
            <a:off x="2514025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 rot="16200000">
            <a:off x="1588149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/>
          <p:cNvSpPr txBox="1"/>
          <p:nvPr/>
        </p:nvSpPr>
        <p:spPr>
          <a:xfrm rot="16200000">
            <a:off x="3073696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 rot="16200000">
            <a:off x="3340198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/>
          <p:cNvSpPr txBox="1"/>
          <p:nvPr/>
        </p:nvSpPr>
        <p:spPr>
          <a:xfrm rot="16200000">
            <a:off x="4272957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/>
          <p:cNvSpPr txBox="1"/>
          <p:nvPr/>
        </p:nvSpPr>
        <p:spPr>
          <a:xfrm rot="16200000">
            <a:off x="3473449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/>
          <p:cNvSpPr txBox="1"/>
          <p:nvPr/>
        </p:nvSpPr>
        <p:spPr>
          <a:xfrm rot="16200000">
            <a:off x="3606700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 rot="16200000">
            <a:off x="3739951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/>
          <p:cNvSpPr txBox="1"/>
          <p:nvPr/>
        </p:nvSpPr>
        <p:spPr>
          <a:xfrm rot="16200000">
            <a:off x="3171681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/>
          <p:cNvSpPr txBox="1"/>
          <p:nvPr/>
        </p:nvSpPr>
        <p:spPr>
          <a:xfrm rot="16200000">
            <a:off x="3837936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/>
          <p:cNvSpPr txBox="1"/>
          <p:nvPr/>
        </p:nvSpPr>
        <p:spPr>
          <a:xfrm rot="16200000">
            <a:off x="3971187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271"/>
          <p:cNvSpPr txBox="1"/>
          <p:nvPr/>
        </p:nvSpPr>
        <p:spPr>
          <a:xfrm rot="16200000">
            <a:off x="4104438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/>
          <p:cNvSpPr txBox="1"/>
          <p:nvPr/>
        </p:nvSpPr>
        <p:spPr>
          <a:xfrm rot="16200000">
            <a:off x="5852975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Box 273"/>
          <p:cNvSpPr txBox="1"/>
          <p:nvPr/>
        </p:nvSpPr>
        <p:spPr>
          <a:xfrm rot="16200000">
            <a:off x="4525665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274"/>
          <p:cNvSpPr txBox="1"/>
          <p:nvPr/>
        </p:nvSpPr>
        <p:spPr>
          <a:xfrm rot="16200000">
            <a:off x="4923858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/>
          <p:cNvSpPr txBox="1"/>
          <p:nvPr/>
        </p:nvSpPr>
        <p:spPr>
          <a:xfrm rot="16200000">
            <a:off x="4658396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276"/>
          <p:cNvSpPr txBox="1"/>
          <p:nvPr/>
        </p:nvSpPr>
        <p:spPr>
          <a:xfrm rot="16200000">
            <a:off x="5056589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 rot="16200000">
            <a:off x="5189320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 rot="16200000">
            <a:off x="5322051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/>
          <p:cNvSpPr txBox="1"/>
          <p:nvPr/>
        </p:nvSpPr>
        <p:spPr>
          <a:xfrm rot="16200000">
            <a:off x="5985706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/>
          <p:cNvSpPr txBox="1"/>
          <p:nvPr/>
        </p:nvSpPr>
        <p:spPr>
          <a:xfrm rot="16200000">
            <a:off x="5454782" y="4279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/>
          <p:cNvSpPr txBox="1"/>
          <p:nvPr/>
        </p:nvSpPr>
        <p:spPr>
          <a:xfrm rot="16200000">
            <a:off x="6083171" y="43144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282"/>
          <p:cNvSpPr txBox="1"/>
          <p:nvPr/>
        </p:nvSpPr>
        <p:spPr>
          <a:xfrm rot="16200000">
            <a:off x="5552247" y="43144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TextBox 283"/>
          <p:cNvSpPr txBox="1"/>
          <p:nvPr/>
        </p:nvSpPr>
        <p:spPr>
          <a:xfrm rot="16200000">
            <a:off x="5684978" y="43144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284"/>
          <p:cNvSpPr txBox="1"/>
          <p:nvPr/>
        </p:nvSpPr>
        <p:spPr>
          <a:xfrm rot="16200000">
            <a:off x="6190026" y="4287799"/>
            <a:ext cx="3774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/>
          <p:cNvSpPr txBox="1"/>
          <p:nvPr/>
        </p:nvSpPr>
        <p:spPr>
          <a:xfrm rot="16200000">
            <a:off x="4755861" y="43144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286"/>
          <p:cNvSpPr txBox="1"/>
          <p:nvPr/>
        </p:nvSpPr>
        <p:spPr>
          <a:xfrm rot="16200000">
            <a:off x="6788990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 rot="16200000">
            <a:off x="6523158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/>
          <p:cNvSpPr txBox="1"/>
          <p:nvPr/>
        </p:nvSpPr>
        <p:spPr>
          <a:xfrm rot="16200000">
            <a:off x="6921906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 rot="16200000">
            <a:off x="7054822" y="427920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 rot="16200000">
            <a:off x="7418307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 rot="16200000">
            <a:off x="7152472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292"/>
          <p:cNvSpPr txBox="1"/>
          <p:nvPr/>
        </p:nvSpPr>
        <p:spPr>
          <a:xfrm rot="16200000">
            <a:off x="6620808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 rot="16200000">
            <a:off x="7285388" y="43144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5" name="그룹 294"/>
          <p:cNvGrpSpPr/>
          <p:nvPr/>
        </p:nvGrpSpPr>
        <p:grpSpPr>
          <a:xfrm>
            <a:off x="7769949" y="4421669"/>
            <a:ext cx="1062987" cy="339869"/>
            <a:chOff x="7776170" y="604871"/>
            <a:chExt cx="1062987" cy="339869"/>
          </a:xfrm>
        </p:grpSpPr>
        <p:sp>
          <p:nvSpPr>
            <p:cNvPr id="296" name="TextBox 295"/>
            <p:cNvSpPr txBox="1"/>
            <p:nvPr/>
          </p:nvSpPr>
          <p:spPr>
            <a:xfrm>
              <a:off x="7776170" y="636963"/>
              <a:ext cx="4235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t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TextBox 296"/>
            <p:cNvSpPr txBox="1"/>
            <p:nvPr/>
          </p:nvSpPr>
          <p:spPr>
            <a:xfrm>
              <a:off x="8205650" y="636963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A21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8" name="Straight Connector 23"/>
            <p:cNvCxnSpPr/>
            <p:nvPr/>
          </p:nvCxnSpPr>
          <p:spPr>
            <a:xfrm>
              <a:off x="7778151" y="604871"/>
              <a:ext cx="416365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Straight Connector 23"/>
            <p:cNvCxnSpPr/>
            <p:nvPr/>
          </p:nvCxnSpPr>
          <p:spPr>
            <a:xfrm>
              <a:off x="8297958" y="606798"/>
              <a:ext cx="458002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0" name="그룹 299"/>
          <p:cNvGrpSpPr/>
          <p:nvPr/>
        </p:nvGrpSpPr>
        <p:grpSpPr>
          <a:xfrm>
            <a:off x="1161399" y="4607422"/>
            <a:ext cx="6454124" cy="598281"/>
            <a:chOff x="1167620" y="770068"/>
            <a:chExt cx="6454124" cy="598281"/>
          </a:xfrm>
        </p:grpSpPr>
        <p:sp>
          <p:nvSpPr>
            <p:cNvPr id="301" name="TextBox 300"/>
            <p:cNvSpPr txBox="1"/>
            <p:nvPr/>
          </p:nvSpPr>
          <p:spPr>
            <a:xfrm>
              <a:off x="3806217" y="1060572"/>
              <a:ext cx="1340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ox/XA21</a:t>
              </a:r>
              <a:endParaRPr lang="ko-KR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2" name="Straight Connector 26"/>
            <p:cNvCxnSpPr/>
            <p:nvPr/>
          </p:nvCxnSpPr>
          <p:spPr>
            <a:xfrm>
              <a:off x="1167620" y="770068"/>
              <a:ext cx="1821602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3" name="TextBox 302"/>
            <p:cNvSpPr txBox="1"/>
            <p:nvPr/>
          </p:nvSpPr>
          <p:spPr>
            <a:xfrm>
              <a:off x="1903270" y="778693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A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4" name="Straight Connector 26"/>
            <p:cNvCxnSpPr/>
            <p:nvPr/>
          </p:nvCxnSpPr>
          <p:spPr>
            <a:xfrm>
              <a:off x="1587150" y="1050585"/>
              <a:ext cx="5716968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Straight Connector 26"/>
            <p:cNvCxnSpPr/>
            <p:nvPr/>
          </p:nvCxnSpPr>
          <p:spPr>
            <a:xfrm>
              <a:off x="3132254" y="771993"/>
              <a:ext cx="1368596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Straight Connector 26"/>
            <p:cNvCxnSpPr/>
            <p:nvPr/>
          </p:nvCxnSpPr>
          <p:spPr>
            <a:xfrm>
              <a:off x="4632306" y="773921"/>
              <a:ext cx="1821602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Straight Connector 26"/>
            <p:cNvCxnSpPr/>
            <p:nvPr/>
          </p:nvCxnSpPr>
          <p:spPr>
            <a:xfrm>
              <a:off x="6593498" y="775852"/>
              <a:ext cx="1028246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" name="TextBox 307"/>
            <p:cNvSpPr txBox="1"/>
            <p:nvPr/>
          </p:nvSpPr>
          <p:spPr>
            <a:xfrm>
              <a:off x="3629822" y="778693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A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5379528" y="778693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A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TextBox 309"/>
            <p:cNvSpPr txBox="1"/>
            <p:nvPr/>
          </p:nvSpPr>
          <p:spPr>
            <a:xfrm>
              <a:off x="6955609" y="778693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A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6" name="TextBox 125"/>
          <p:cNvSpPr txBox="1"/>
          <p:nvPr/>
        </p:nvSpPr>
        <p:spPr>
          <a:xfrm>
            <a:off x="2695604" y="298479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7" name="그룹 126"/>
          <p:cNvGrpSpPr/>
          <p:nvPr/>
        </p:nvGrpSpPr>
        <p:grpSpPr>
          <a:xfrm>
            <a:off x="1796280" y="3282833"/>
            <a:ext cx="899407" cy="49106"/>
            <a:chOff x="5206111" y="592667"/>
            <a:chExt cx="1593343" cy="778991"/>
          </a:xfrm>
        </p:grpSpPr>
        <p:cxnSp>
          <p:nvCxnSpPr>
            <p:cNvPr id="128" name="직선 연결선 12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직선 연결선 12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직선 연결선 12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1" name="그룹 130"/>
          <p:cNvGrpSpPr/>
          <p:nvPr/>
        </p:nvGrpSpPr>
        <p:grpSpPr>
          <a:xfrm>
            <a:off x="5913412" y="3030634"/>
            <a:ext cx="507692" cy="49106"/>
            <a:chOff x="5206111" y="592667"/>
            <a:chExt cx="1593343" cy="778991"/>
          </a:xfrm>
        </p:grpSpPr>
        <p:cxnSp>
          <p:nvCxnSpPr>
            <p:cNvPr id="132" name="직선 연결선 131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직선 연결선 140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직선 연결선 147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9" name="TextBox 148"/>
          <p:cNvSpPr txBox="1"/>
          <p:nvPr/>
        </p:nvSpPr>
        <p:spPr>
          <a:xfrm>
            <a:off x="6053191" y="278397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58709" y="5219276"/>
            <a:ext cx="824082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8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1 progeny from XB21 overexpressing XA21 transgenic plants (XB21ox/XA21) display cell death and enhanced resistance to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ion lengths measured 12 days after inoculation from XA21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progeny from 2A, 3A, 5A, and 6A), XA21 transgenic plants (23A-1-14), and Kitaake wild type plants. The error bars represent standard error of at least three leaves from each plant. Gray bar, progeny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in the absence of cell death; Black bar, progeny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in the presence of cell death; White bar, progeny not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777466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2" cstate="print"/>
          <a:srcRect l="8824" t="28927" b="24789"/>
          <a:stretch>
            <a:fillRect/>
          </a:stretch>
        </p:blipFill>
        <p:spPr bwMode="auto">
          <a:xfrm>
            <a:off x="2438400" y="2982511"/>
            <a:ext cx="47244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5" name="Picture 7"/>
          <p:cNvPicPr>
            <a:picLocks noChangeAspect="1" noChangeArrowheads="1"/>
          </p:cNvPicPr>
          <p:nvPr/>
        </p:nvPicPr>
        <p:blipFill>
          <a:blip r:embed="rId3" cstate="print"/>
          <a:srcRect l="11306" t="20168" r="1070" b="26050"/>
          <a:stretch>
            <a:fillRect/>
          </a:stretch>
        </p:blipFill>
        <p:spPr bwMode="auto">
          <a:xfrm>
            <a:off x="2438400" y="2342696"/>
            <a:ext cx="47244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1446545" y="3150586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18s </a:t>
            </a:r>
            <a:r>
              <a:rPr lang="en-US" sz="14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RNA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05617" y="2501246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XB21</a:t>
            </a:r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048000" y="1821110"/>
            <a:ext cx="1211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3103245" y="1793982"/>
            <a:ext cx="1089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429000" y="1447800"/>
            <a:ext cx="31945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A                       3A                        5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73352" y="1068943"/>
            <a:ext cx="1503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XA2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3581400" y="1438275"/>
            <a:ext cx="2895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2487509" y="1625578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596503" y="2029847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</a:t>
            </a:r>
            <a:endParaRPr lang="ko-KR" altLang="en-US" sz="14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607762" y="2029847"/>
            <a:ext cx="4374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++-++-+-+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747956" y="1821110"/>
            <a:ext cx="12779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     13     1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404164" y="1821110"/>
            <a:ext cx="1211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15"/>
          <p:cNvCxnSpPr/>
          <p:nvPr/>
        </p:nvCxnSpPr>
        <p:spPr>
          <a:xfrm>
            <a:off x="4447840" y="1793982"/>
            <a:ext cx="1089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15"/>
          <p:cNvCxnSpPr/>
          <p:nvPr/>
        </p:nvCxnSpPr>
        <p:spPr>
          <a:xfrm>
            <a:off x="5815579" y="1793982"/>
            <a:ext cx="1089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9</a:t>
            </a:r>
            <a:endParaRPr lang="ko-KR" alt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441788" y="4674742"/>
            <a:ext cx="828097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9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A21 plants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(XB21ox/XA21) overexpress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RNA was extracted from four-week old stage of 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(progeny from 4A, 5A, and 10B) and Kit wild type plants, and RT-PCR was performed with specific primers for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geny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was labelled with ‘+’ and non-transgenic segregants was labelled with ‘-’. Control RT-PCR reaction was carried out with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S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perimental results were repeated twice, with similar results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0657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l="9819" t="4079" r="53270" b="38284"/>
          <a:stretch/>
        </p:blipFill>
        <p:spPr>
          <a:xfrm>
            <a:off x="1365846" y="1397001"/>
            <a:ext cx="6997866" cy="3073400"/>
          </a:xfrm>
          <a:prstGeom prst="rect">
            <a:avLst/>
          </a:prstGeom>
        </p:spPr>
      </p:pic>
      <p:grpSp>
        <p:nvGrpSpPr>
          <p:cNvPr id="5" name="그룹 4"/>
          <p:cNvGrpSpPr/>
          <p:nvPr/>
        </p:nvGrpSpPr>
        <p:grpSpPr>
          <a:xfrm>
            <a:off x="-25400" y="1346201"/>
            <a:ext cx="1455848" cy="452207"/>
            <a:chOff x="-25400" y="1358901"/>
            <a:chExt cx="1455848" cy="452207"/>
          </a:xfrm>
        </p:grpSpPr>
        <p:sp>
          <p:nvSpPr>
            <p:cNvPr id="3" name="TextBox 2"/>
            <p:cNvSpPr txBox="1"/>
            <p:nvPr/>
          </p:nvSpPr>
          <p:spPr>
            <a:xfrm>
              <a:off x="421839" y="1549498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-25400" y="1358901"/>
              <a:ext cx="1455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-25400" y="1879601"/>
            <a:ext cx="1455848" cy="452207"/>
            <a:chOff x="-25400" y="1358901"/>
            <a:chExt cx="1455848" cy="452207"/>
          </a:xfrm>
        </p:grpSpPr>
        <p:sp>
          <p:nvSpPr>
            <p:cNvPr id="7" name="TextBox 6"/>
            <p:cNvSpPr txBox="1"/>
            <p:nvPr/>
          </p:nvSpPr>
          <p:spPr>
            <a:xfrm>
              <a:off x="421839" y="1549498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25400" y="1358901"/>
              <a:ext cx="1455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-25400" y="2413001"/>
            <a:ext cx="1455848" cy="452207"/>
            <a:chOff x="-25400" y="1358901"/>
            <a:chExt cx="1455848" cy="452207"/>
          </a:xfrm>
        </p:grpSpPr>
        <p:sp>
          <p:nvSpPr>
            <p:cNvPr id="10" name="TextBox 9"/>
            <p:cNvSpPr txBox="1"/>
            <p:nvPr/>
          </p:nvSpPr>
          <p:spPr>
            <a:xfrm>
              <a:off x="421839" y="1549498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-25400" y="1358901"/>
              <a:ext cx="1455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-25400" y="2946401"/>
            <a:ext cx="1455848" cy="452207"/>
            <a:chOff x="-25400" y="1358901"/>
            <a:chExt cx="1455848" cy="452207"/>
          </a:xfrm>
        </p:grpSpPr>
        <p:sp>
          <p:nvSpPr>
            <p:cNvPr id="13" name="TextBox 12"/>
            <p:cNvSpPr txBox="1"/>
            <p:nvPr/>
          </p:nvSpPr>
          <p:spPr>
            <a:xfrm>
              <a:off x="421839" y="1549498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-25400" y="1358901"/>
              <a:ext cx="1455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그룹 14"/>
          <p:cNvGrpSpPr/>
          <p:nvPr/>
        </p:nvGrpSpPr>
        <p:grpSpPr>
          <a:xfrm>
            <a:off x="-25400" y="3479801"/>
            <a:ext cx="1455848" cy="452207"/>
            <a:chOff x="-25400" y="1358901"/>
            <a:chExt cx="1455848" cy="452207"/>
          </a:xfrm>
        </p:grpSpPr>
        <p:sp>
          <p:nvSpPr>
            <p:cNvPr id="16" name="TextBox 15"/>
            <p:cNvSpPr txBox="1"/>
            <p:nvPr/>
          </p:nvSpPr>
          <p:spPr>
            <a:xfrm>
              <a:off x="421839" y="1549498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-25400" y="1358901"/>
              <a:ext cx="1455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그룹 17"/>
          <p:cNvGrpSpPr/>
          <p:nvPr/>
        </p:nvGrpSpPr>
        <p:grpSpPr>
          <a:xfrm>
            <a:off x="-25400" y="4013201"/>
            <a:ext cx="1455848" cy="452207"/>
            <a:chOff x="-25400" y="1358901"/>
            <a:chExt cx="1455848" cy="452207"/>
          </a:xfrm>
        </p:grpSpPr>
        <p:sp>
          <p:nvSpPr>
            <p:cNvPr id="19" name="TextBox 18"/>
            <p:cNvSpPr txBox="1"/>
            <p:nvPr/>
          </p:nvSpPr>
          <p:spPr>
            <a:xfrm>
              <a:off x="421839" y="1549498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11g4395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-25400" y="1358901"/>
              <a:ext cx="1455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-Os12g36180</a:t>
              </a:r>
              <a:endParaRPr lang="ko-KR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8278368" y="1339177"/>
            <a:ext cx="42030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95</a:t>
            </a:r>
          </a:p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82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8278368" y="1874403"/>
            <a:ext cx="42030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63</a:t>
            </a:r>
          </a:p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6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278368" y="2409629"/>
            <a:ext cx="42030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31</a:t>
            </a:r>
          </a:p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30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278368" y="2944855"/>
            <a:ext cx="42030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05</a:t>
            </a:r>
          </a:p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04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278368" y="3480081"/>
            <a:ext cx="420308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79</a:t>
            </a:r>
          </a:p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78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278368" y="4015305"/>
            <a:ext cx="498855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2</a:t>
            </a:r>
          </a:p>
          <a:p>
            <a:pPr>
              <a:lnSpc>
                <a:spcPts val="16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5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화살표 연결선 31"/>
          <p:cNvCxnSpPr/>
          <p:nvPr/>
        </p:nvCxnSpPr>
        <p:spPr>
          <a:xfrm>
            <a:off x="1548384" y="1339177"/>
            <a:ext cx="208483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화살표 연결선 36"/>
          <p:cNvCxnSpPr/>
          <p:nvPr/>
        </p:nvCxnSpPr>
        <p:spPr>
          <a:xfrm flipH="1">
            <a:off x="5974080" y="4013201"/>
            <a:ext cx="230428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217140" y="1120002"/>
            <a:ext cx="7024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endParaRPr lang="ko-KR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827410" y="3824353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verse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-974" y="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10</a:t>
            </a:r>
            <a:endParaRPr lang="ko-KR" alt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421839" y="5024063"/>
            <a:ext cx="82768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0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partial nucleotide sequence used for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ilencing and one of its closely related putative ALP Os11g43950. Arrow lines (labelled with Forward and Reverse) over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indicates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fic primers used for PCR amplification and following construction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45448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9743822"/>
              </p:ext>
            </p:extLst>
          </p:nvPr>
        </p:nvGraphicFramePr>
        <p:xfrm>
          <a:off x="553050" y="1076517"/>
          <a:ext cx="8108443" cy="396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79" name="SPW 11.0 Graph" r:id="rId3" imgW="4989240" imgH="3962880" progId="SigmaPlotGraphicObject.10">
                  <p:embed/>
                </p:oleObj>
              </mc:Choice>
              <mc:Fallback>
                <p:oleObj name="SPW 11.0 Graph" r:id="rId3" imgW="4989240" imgH="396288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3050" y="1076517"/>
                        <a:ext cx="8108443" cy="396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120652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139006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57360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75714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194068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212422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230776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2491307" y="483448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889208" y="4836414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5072838" y="4836414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5217195" y="4836414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400825" y="4836414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5584455" y="4836414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5768085" y="4836414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5951716" y="4836414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850460" y="4920088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813570" y="4920088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6"/>
          <p:cNvCxnSpPr/>
          <p:nvPr/>
        </p:nvCxnSpPr>
        <p:spPr>
          <a:xfrm>
            <a:off x="1325872" y="5134147"/>
            <a:ext cx="1368592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345231" y="5134147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RNAi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5001315" y="5136075"/>
            <a:ext cx="1244175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958465" y="5136075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RNAi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3"/>
          <p:cNvCxnSpPr/>
          <p:nvPr/>
        </p:nvCxnSpPr>
        <p:spPr>
          <a:xfrm>
            <a:off x="2926306" y="4904455"/>
            <a:ext cx="378514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3"/>
          <p:cNvCxnSpPr/>
          <p:nvPr/>
        </p:nvCxnSpPr>
        <p:spPr>
          <a:xfrm>
            <a:off x="3515067" y="4906382"/>
            <a:ext cx="1079945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23"/>
          <p:cNvCxnSpPr/>
          <p:nvPr/>
        </p:nvCxnSpPr>
        <p:spPr>
          <a:xfrm>
            <a:off x="6435365" y="4894808"/>
            <a:ext cx="378514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23"/>
          <p:cNvCxnSpPr/>
          <p:nvPr/>
        </p:nvCxnSpPr>
        <p:spPr>
          <a:xfrm>
            <a:off x="7026365" y="4896735"/>
            <a:ext cx="89251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244898" y="4922017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334205" y="4922017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-461216" y="3117205"/>
            <a:ext cx="1815123" cy="299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61227" y="4633441"/>
            <a:ext cx="23053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61227" y="3987761"/>
            <a:ext cx="23053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66257" y="3342081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66257" y="2696401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66257" y="2050721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66257" y="1405041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화살표 연결선 45"/>
          <p:cNvCxnSpPr/>
          <p:nvPr/>
        </p:nvCxnSpPr>
        <p:spPr>
          <a:xfrm>
            <a:off x="1258625" y="1568035"/>
            <a:ext cx="3336387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화살표 연결선 46"/>
          <p:cNvCxnSpPr/>
          <p:nvPr/>
        </p:nvCxnSpPr>
        <p:spPr>
          <a:xfrm>
            <a:off x="4877378" y="1568035"/>
            <a:ext cx="3033080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492146" y="1221169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 DAI</a:t>
            </a:r>
            <a:endParaRPr lang="ko-KR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997346" y="1221169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 DAI</a:t>
            </a:r>
            <a:endParaRPr lang="ko-KR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-974" y="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11</a:t>
            </a:r>
            <a:endParaRPr lang="ko-KR" altLang="en-US" sz="12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1189193" y="253704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그룹 43"/>
          <p:cNvGrpSpPr/>
          <p:nvPr/>
        </p:nvGrpSpPr>
        <p:grpSpPr>
          <a:xfrm>
            <a:off x="2941159" y="4208991"/>
            <a:ext cx="346758" cy="49106"/>
            <a:chOff x="5206111" y="592667"/>
            <a:chExt cx="1593343" cy="778991"/>
          </a:xfrm>
        </p:grpSpPr>
        <p:cxnSp>
          <p:nvCxnSpPr>
            <p:cNvPr id="45" name="직선 연결선 4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직선 연결선 4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그룹 51"/>
          <p:cNvGrpSpPr/>
          <p:nvPr/>
        </p:nvGrpSpPr>
        <p:grpSpPr>
          <a:xfrm>
            <a:off x="6442939" y="4279199"/>
            <a:ext cx="346758" cy="49106"/>
            <a:chOff x="5206111" y="592667"/>
            <a:chExt cx="1593343" cy="778991"/>
          </a:xfrm>
        </p:grpSpPr>
        <p:cxnSp>
          <p:nvCxnSpPr>
            <p:cNvPr id="53" name="직선 연결선 5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연결선 54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그룹 55"/>
          <p:cNvGrpSpPr/>
          <p:nvPr/>
        </p:nvGrpSpPr>
        <p:grpSpPr>
          <a:xfrm>
            <a:off x="6976132" y="2531938"/>
            <a:ext cx="899402" cy="49106"/>
            <a:chOff x="5206111" y="592667"/>
            <a:chExt cx="1593343" cy="778991"/>
          </a:xfrm>
        </p:grpSpPr>
        <p:cxnSp>
          <p:nvCxnSpPr>
            <p:cNvPr id="57" name="직선 연결선 56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그룹 59"/>
          <p:cNvGrpSpPr/>
          <p:nvPr/>
        </p:nvGrpSpPr>
        <p:grpSpPr>
          <a:xfrm>
            <a:off x="3479233" y="2365843"/>
            <a:ext cx="1088276" cy="49106"/>
            <a:chOff x="5206111" y="592667"/>
            <a:chExt cx="1593343" cy="778991"/>
          </a:xfrm>
        </p:grpSpPr>
        <p:cxnSp>
          <p:nvCxnSpPr>
            <p:cNvPr id="61" name="직선 연결선 6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TextBox 64"/>
          <p:cNvSpPr txBox="1"/>
          <p:nvPr/>
        </p:nvSpPr>
        <p:spPr>
          <a:xfrm rot="16200000">
            <a:off x="1325471" y="284355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 rot="16200000">
            <a:off x="1509038" y="284184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6200000">
            <a:off x="1739894" y="356959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6200000">
            <a:off x="1923460" y="2396633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2107027" y="3237402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 rot="16200000">
            <a:off x="2290595" y="272983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6200000">
            <a:off x="2521451" y="15774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6200000">
            <a:off x="2979433" y="39764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6200000">
            <a:off x="3883388" y="211654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6200000">
            <a:off x="4870157" y="2756933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 rot="16200000">
            <a:off x="5055624" y="3133618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16200000">
            <a:off x="5241091" y="2768434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5469038" y="3326275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 rot="16200000">
            <a:off x="5612025" y="2779947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16200000">
            <a:off x="5797492" y="2880586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6200000">
            <a:off x="6025438" y="3248641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6200000">
            <a:off x="6476405" y="404234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6200000">
            <a:off x="7287352" y="228559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31515" y="5609020"/>
            <a:ext cx="822997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1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lencing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itaake plants does not exhibit significant difference in lesion lengths after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oculation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ion lengths measured from Kitaake plants silenc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RNAi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2A/B, 3A/B, 4B, 5B, 6A and 7A at 12 DAI and 8A, 9B, 11A, 12A, 13A, 14A, and 16A at 10 DAI), XA21 transgenic plants (23A-1-14), and Kitaake wild type plants. The error bars represent standard error of at least three leaves from each plant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2356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 rot="16200000">
            <a:off x="-727234" y="2618851"/>
            <a:ext cx="1815123" cy="299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8709" y="431288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8709" y="366475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3739" y="301661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3739" y="236848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3739" y="17203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3739" y="107222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63739" y="42408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-974" y="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12</a:t>
            </a:r>
            <a:endParaRPr lang="ko-KR" altLang="en-US" sz="12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539" y="567225"/>
            <a:ext cx="8459262" cy="3937115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 rot="16200000">
            <a:off x="1472086" y="133050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2373435" y="131891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219758" y="1701872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996704" y="1200335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d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397897" y="1522109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114699" y="30632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933155" y="190810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d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837469" y="170642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706782" y="1991892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378377" y="31951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8106778" y="154509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7" name="그룹 76"/>
          <p:cNvGrpSpPr/>
          <p:nvPr/>
        </p:nvGrpSpPr>
        <p:grpSpPr>
          <a:xfrm>
            <a:off x="1162915" y="1960731"/>
            <a:ext cx="419577" cy="49106"/>
            <a:chOff x="5206111" y="592667"/>
            <a:chExt cx="1593343" cy="778991"/>
          </a:xfrm>
        </p:grpSpPr>
        <p:cxnSp>
          <p:nvCxnSpPr>
            <p:cNvPr id="3" name="직선 연결선 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직선 연결선 11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6" name="TextBox 115"/>
          <p:cNvSpPr txBox="1"/>
          <p:nvPr/>
        </p:nvSpPr>
        <p:spPr>
          <a:xfrm>
            <a:off x="2098234" y="2108401"/>
            <a:ext cx="3545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e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7" name="그룹 116"/>
          <p:cNvGrpSpPr/>
          <p:nvPr/>
        </p:nvGrpSpPr>
        <p:grpSpPr>
          <a:xfrm>
            <a:off x="1981962" y="2351885"/>
            <a:ext cx="558461" cy="49106"/>
            <a:chOff x="5206111" y="592667"/>
            <a:chExt cx="1593343" cy="778991"/>
          </a:xfrm>
        </p:grpSpPr>
        <p:cxnSp>
          <p:nvCxnSpPr>
            <p:cNvPr id="118" name="직선 연결선 11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직선 연결선 11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연결선 11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그룹 120"/>
          <p:cNvGrpSpPr/>
          <p:nvPr/>
        </p:nvGrpSpPr>
        <p:grpSpPr>
          <a:xfrm>
            <a:off x="2901653" y="1539887"/>
            <a:ext cx="614307" cy="49106"/>
            <a:chOff x="5206111" y="592667"/>
            <a:chExt cx="1593343" cy="778991"/>
          </a:xfrm>
        </p:grpSpPr>
        <p:cxnSp>
          <p:nvCxnSpPr>
            <p:cNvPr id="122" name="직선 연결선 121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직선 연결선 122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직선 연결선 123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5" name="그룹 124"/>
          <p:cNvGrpSpPr/>
          <p:nvPr/>
        </p:nvGrpSpPr>
        <p:grpSpPr>
          <a:xfrm>
            <a:off x="3505276" y="1743746"/>
            <a:ext cx="315235" cy="49106"/>
            <a:chOff x="5206111" y="592667"/>
            <a:chExt cx="1593343" cy="778991"/>
          </a:xfrm>
        </p:grpSpPr>
        <p:cxnSp>
          <p:nvCxnSpPr>
            <p:cNvPr id="126" name="직선 연결선 125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직선 연결선 126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직선 연결선 127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9" name="TextBox 128"/>
          <p:cNvSpPr txBox="1"/>
          <p:nvPr/>
        </p:nvSpPr>
        <p:spPr>
          <a:xfrm>
            <a:off x="4446249" y="1010608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0" name="그룹 129"/>
          <p:cNvGrpSpPr/>
          <p:nvPr/>
        </p:nvGrpSpPr>
        <p:grpSpPr>
          <a:xfrm>
            <a:off x="4500688" y="1215992"/>
            <a:ext cx="260525" cy="49106"/>
            <a:chOff x="5206111" y="592667"/>
            <a:chExt cx="1593343" cy="778991"/>
          </a:xfrm>
        </p:grpSpPr>
        <p:cxnSp>
          <p:nvCxnSpPr>
            <p:cNvPr id="131" name="직선 연결선 13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직선 연결선 13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직선 연결선 13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4" name="그룹 133"/>
          <p:cNvGrpSpPr/>
          <p:nvPr/>
        </p:nvGrpSpPr>
        <p:grpSpPr>
          <a:xfrm>
            <a:off x="4040075" y="528800"/>
            <a:ext cx="419577" cy="49106"/>
            <a:chOff x="5206111" y="592667"/>
            <a:chExt cx="1593343" cy="778991"/>
          </a:xfrm>
        </p:grpSpPr>
        <p:cxnSp>
          <p:nvCxnSpPr>
            <p:cNvPr id="135" name="직선 연결선 13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직선 연결선 13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직선 연결선 136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그룹 137"/>
          <p:cNvGrpSpPr/>
          <p:nvPr/>
        </p:nvGrpSpPr>
        <p:grpSpPr>
          <a:xfrm>
            <a:off x="4951320" y="2140799"/>
            <a:ext cx="419577" cy="49106"/>
            <a:chOff x="5206111" y="592667"/>
            <a:chExt cx="1593343" cy="778991"/>
          </a:xfrm>
        </p:grpSpPr>
        <p:cxnSp>
          <p:nvCxnSpPr>
            <p:cNvPr id="139" name="직선 연결선 138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직선 연결선 13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직선 연결선 14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2" name="그룹 141"/>
          <p:cNvGrpSpPr/>
          <p:nvPr/>
        </p:nvGrpSpPr>
        <p:grpSpPr>
          <a:xfrm>
            <a:off x="5572146" y="1944250"/>
            <a:ext cx="899402" cy="49106"/>
            <a:chOff x="5206111" y="592667"/>
            <a:chExt cx="1593343" cy="778991"/>
          </a:xfrm>
        </p:grpSpPr>
        <p:cxnSp>
          <p:nvCxnSpPr>
            <p:cNvPr id="143" name="직선 연결선 14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직선 연결선 143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직선 연결선 144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" name="그룹 145"/>
          <p:cNvGrpSpPr/>
          <p:nvPr/>
        </p:nvGrpSpPr>
        <p:grpSpPr>
          <a:xfrm>
            <a:off x="6664153" y="2233444"/>
            <a:ext cx="461535" cy="49106"/>
            <a:chOff x="5206111" y="592667"/>
            <a:chExt cx="1593343" cy="778991"/>
          </a:xfrm>
        </p:grpSpPr>
        <p:cxnSp>
          <p:nvCxnSpPr>
            <p:cNvPr id="147" name="직선 연결선 146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직선 연결선 147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직선 연결선 148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0" name="그룹 149"/>
          <p:cNvGrpSpPr/>
          <p:nvPr/>
        </p:nvGrpSpPr>
        <p:grpSpPr>
          <a:xfrm>
            <a:off x="7282576" y="3423607"/>
            <a:ext cx="461535" cy="49106"/>
            <a:chOff x="5206111" y="592667"/>
            <a:chExt cx="1593343" cy="778991"/>
          </a:xfrm>
        </p:grpSpPr>
        <p:cxnSp>
          <p:nvCxnSpPr>
            <p:cNvPr id="151" name="직선 연결선 15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직선 연결선 15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직선 연결선 15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4" name="그룹 153"/>
          <p:cNvGrpSpPr/>
          <p:nvPr/>
        </p:nvGrpSpPr>
        <p:grpSpPr>
          <a:xfrm>
            <a:off x="7907501" y="1783382"/>
            <a:ext cx="817638" cy="49106"/>
            <a:chOff x="5206111" y="592667"/>
            <a:chExt cx="1593343" cy="778991"/>
          </a:xfrm>
        </p:grpSpPr>
        <p:cxnSp>
          <p:nvCxnSpPr>
            <p:cNvPr id="155" name="직선 연결선 15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직선 연결선 15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직선 연결선 156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9" name="TextBox 158"/>
          <p:cNvSpPr txBox="1"/>
          <p:nvPr/>
        </p:nvSpPr>
        <p:spPr>
          <a:xfrm>
            <a:off x="8165285" y="4611082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7236345" y="4611082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3631231" y="5036505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RNAi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109245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238777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366053" y="450734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1524251" y="450734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87871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2041148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2528457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2203585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2366022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283121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299322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315524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3641288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347927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331725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4434590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4578524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3953202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4059036" y="450734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4229357" y="450734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488861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504736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5206111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552678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568553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584428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600303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632053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616178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663803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679678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6955536" y="450734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Straight Connector 26"/>
          <p:cNvCxnSpPr/>
          <p:nvPr/>
        </p:nvCxnSpPr>
        <p:spPr>
          <a:xfrm>
            <a:off x="1970166" y="4750293"/>
            <a:ext cx="702305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26"/>
          <p:cNvCxnSpPr/>
          <p:nvPr/>
        </p:nvCxnSpPr>
        <p:spPr>
          <a:xfrm>
            <a:off x="2915598" y="4750293"/>
            <a:ext cx="84979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26"/>
          <p:cNvCxnSpPr/>
          <p:nvPr/>
        </p:nvCxnSpPr>
        <p:spPr>
          <a:xfrm>
            <a:off x="4001975" y="4750293"/>
            <a:ext cx="77253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Connector 26"/>
          <p:cNvCxnSpPr/>
          <p:nvPr/>
        </p:nvCxnSpPr>
        <p:spPr>
          <a:xfrm>
            <a:off x="5620698" y="4750293"/>
            <a:ext cx="84979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26"/>
          <p:cNvCxnSpPr/>
          <p:nvPr/>
        </p:nvCxnSpPr>
        <p:spPr>
          <a:xfrm>
            <a:off x="6703855" y="4750293"/>
            <a:ext cx="43607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Connector 26"/>
          <p:cNvCxnSpPr/>
          <p:nvPr/>
        </p:nvCxnSpPr>
        <p:spPr>
          <a:xfrm>
            <a:off x="4970305" y="4750293"/>
            <a:ext cx="43607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26"/>
          <p:cNvCxnSpPr/>
          <p:nvPr/>
        </p:nvCxnSpPr>
        <p:spPr>
          <a:xfrm>
            <a:off x="1173860" y="4750293"/>
            <a:ext cx="580417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200"/>
          <p:cNvSpPr txBox="1"/>
          <p:nvPr/>
        </p:nvSpPr>
        <p:spPr>
          <a:xfrm>
            <a:off x="1292476" y="477131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2140201" y="477131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3169918" y="477131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4216641" y="477131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4961548" y="4771311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5837848" y="4771311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6704623" y="4771311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8" name="Straight Connector 26"/>
          <p:cNvCxnSpPr/>
          <p:nvPr/>
        </p:nvCxnSpPr>
        <p:spPr>
          <a:xfrm>
            <a:off x="1358309" y="5026518"/>
            <a:ext cx="571696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Connector 23"/>
          <p:cNvCxnSpPr/>
          <p:nvPr/>
        </p:nvCxnSpPr>
        <p:spPr>
          <a:xfrm>
            <a:off x="7343540" y="4591690"/>
            <a:ext cx="416365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3"/>
          <p:cNvCxnSpPr/>
          <p:nvPr/>
        </p:nvCxnSpPr>
        <p:spPr>
          <a:xfrm>
            <a:off x="7992815" y="4593617"/>
            <a:ext cx="73761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458710" y="5640512"/>
            <a:ext cx="827172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2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 of XB21RNAi/Kit do not display alteration of resistance to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ion lengths measured 12 days after inoculation from Kitaake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RNAi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progeny from 3B, 5B, 7A, 8A, 12A, 14A, and 16A), XA21 transgenic plants (23A-1-14), and Kitaake wild type plants. Progeny not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RNAi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 are labeled with a white bar. The error bars represent standard error of at least three leaves from each plant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0007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31515" y="369870"/>
            <a:ext cx="828097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s sequence alignment of ALPs from rice (XB21-Os12g36180 and Os11g43950) and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t4g12770 and At4g12780). Dashes indicate gaps. The numbers at each row to the right indicate the position in the sequence of the last amino acid in the row. Black-shaded residues are identical. ‘*’ and ‘box’ indicate an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xD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xF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tif and a DPF AP-2 binding motif, respectively. The line above the alignment notes the conserved sequence HPD that binds to Hsc70. The dashed line under the alignment indicates the auxilin-like-C-terminal domain including a J-domain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3584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4404065"/>
              </p:ext>
            </p:extLst>
          </p:nvPr>
        </p:nvGraphicFramePr>
        <p:xfrm>
          <a:off x="942461" y="588633"/>
          <a:ext cx="7822875" cy="4012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48" name="SPW 11.0 Graph" r:id="rId3" imgW="4989240" imgH="3962880" progId="SigmaPlotGraphicObject.10">
                  <p:embed/>
                </p:oleObj>
              </mc:Choice>
              <mc:Fallback>
                <p:oleObj name="SPW 11.0 Graph" r:id="rId3" imgW="4989240" imgH="3962880" progId="SigmaPlotGraphicObject.10">
                  <p:embed/>
                  <p:pic>
                    <p:nvPicPr>
                      <p:cNvPr id="4" name="개체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42461" y="588633"/>
                        <a:ext cx="7822875" cy="40122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1555844" y="439998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1722521" y="439998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889198" y="439998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2055875" y="439998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170001" y="4399982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334341" y="4399982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498681" y="4399982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4663021" y="4399982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478808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495242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511676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240860" y="4523684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330970" y="452368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6"/>
          <p:cNvCxnSpPr/>
          <p:nvPr/>
        </p:nvCxnSpPr>
        <p:spPr>
          <a:xfrm>
            <a:off x="1688491" y="4765071"/>
            <a:ext cx="580417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437353" y="4750347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Kit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4318136" y="4765071"/>
            <a:ext cx="2204133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869565" y="4750347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3"/>
          <p:cNvCxnSpPr/>
          <p:nvPr/>
        </p:nvCxnSpPr>
        <p:spPr>
          <a:xfrm>
            <a:off x="2456406" y="4508051"/>
            <a:ext cx="378514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3"/>
          <p:cNvCxnSpPr/>
          <p:nvPr/>
        </p:nvCxnSpPr>
        <p:spPr>
          <a:xfrm>
            <a:off x="2954555" y="4509978"/>
            <a:ext cx="98176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23"/>
          <p:cNvCxnSpPr/>
          <p:nvPr/>
        </p:nvCxnSpPr>
        <p:spPr>
          <a:xfrm>
            <a:off x="6719144" y="4509978"/>
            <a:ext cx="378514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23"/>
          <p:cNvCxnSpPr/>
          <p:nvPr/>
        </p:nvCxnSpPr>
        <p:spPr>
          <a:xfrm>
            <a:off x="7236413" y="4509978"/>
            <a:ext cx="81137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439777" y="4523684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592584" y="452368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-178966" y="2682701"/>
            <a:ext cx="1815123" cy="299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43477" y="4198937"/>
            <a:ext cx="23053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943477" y="3553257"/>
            <a:ext cx="23053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48507" y="2907577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48507" y="2261897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48507" y="1616217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48507" y="970537"/>
            <a:ext cx="311193" cy="2497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화살표 연결선 45"/>
          <p:cNvCxnSpPr/>
          <p:nvPr/>
        </p:nvCxnSpPr>
        <p:spPr>
          <a:xfrm>
            <a:off x="1464142" y="1070031"/>
            <a:ext cx="2506677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화살표 연결선 46"/>
          <p:cNvCxnSpPr/>
          <p:nvPr/>
        </p:nvCxnSpPr>
        <p:spPr>
          <a:xfrm>
            <a:off x="4241405" y="1070031"/>
            <a:ext cx="3670027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299047" y="636389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 DAI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591223" y="634866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 DAI</a:t>
            </a:r>
            <a:endParaRPr lang="ko-KR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528110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544544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560978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577412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593846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6102808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6200000">
            <a:off x="6267142" y="4439255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1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2</a:t>
            </a:r>
            <a:endParaRPr lang="ko-KR" altLang="en-US" sz="1200" dirty="0"/>
          </a:p>
        </p:txBody>
      </p:sp>
      <p:sp>
        <p:nvSpPr>
          <p:cNvPr id="2" name="TextBox 1"/>
          <p:cNvSpPr txBox="1"/>
          <p:nvPr/>
        </p:nvSpPr>
        <p:spPr>
          <a:xfrm rot="16200000">
            <a:off x="1537212" y="173173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1699886" y="119577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1911496" y="11155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2085381" y="34581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그룹 59"/>
          <p:cNvGrpSpPr/>
          <p:nvPr/>
        </p:nvGrpSpPr>
        <p:grpSpPr>
          <a:xfrm>
            <a:off x="2471989" y="3762145"/>
            <a:ext cx="286577" cy="49106"/>
            <a:chOff x="5206111" y="592667"/>
            <a:chExt cx="1593343" cy="778991"/>
          </a:xfrm>
        </p:grpSpPr>
        <p:cxnSp>
          <p:nvCxnSpPr>
            <p:cNvPr id="61" name="직선 연결선 6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그룹 63"/>
          <p:cNvGrpSpPr/>
          <p:nvPr/>
        </p:nvGrpSpPr>
        <p:grpSpPr>
          <a:xfrm>
            <a:off x="2982210" y="1852837"/>
            <a:ext cx="899406" cy="49106"/>
            <a:chOff x="5206111" y="592667"/>
            <a:chExt cx="1593343" cy="778991"/>
          </a:xfrm>
        </p:grpSpPr>
        <p:cxnSp>
          <p:nvCxnSpPr>
            <p:cNvPr id="65" name="직선 연결선 6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그룹 67"/>
          <p:cNvGrpSpPr/>
          <p:nvPr/>
        </p:nvGrpSpPr>
        <p:grpSpPr>
          <a:xfrm>
            <a:off x="7212645" y="2013863"/>
            <a:ext cx="817642" cy="49106"/>
            <a:chOff x="5206111" y="592667"/>
            <a:chExt cx="1593343" cy="778991"/>
          </a:xfrm>
        </p:grpSpPr>
        <p:cxnSp>
          <p:nvCxnSpPr>
            <p:cNvPr id="69" name="직선 연결선 68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그룹 71"/>
          <p:cNvGrpSpPr/>
          <p:nvPr/>
        </p:nvGrpSpPr>
        <p:grpSpPr>
          <a:xfrm>
            <a:off x="6719099" y="3865660"/>
            <a:ext cx="315235" cy="49106"/>
            <a:chOff x="5206111" y="592667"/>
            <a:chExt cx="1593343" cy="778991"/>
          </a:xfrm>
        </p:grpSpPr>
        <p:cxnSp>
          <p:nvCxnSpPr>
            <p:cNvPr id="73" name="직선 연결선 7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직선 연결선 74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" name="TextBox 75"/>
          <p:cNvSpPr txBox="1"/>
          <p:nvPr/>
        </p:nvSpPr>
        <p:spPr>
          <a:xfrm rot="16200000">
            <a:off x="2496575" y="354156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3282524" y="160637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 rot="16200000">
            <a:off x="4145377" y="248688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f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16200000">
            <a:off x="4347040" y="3267467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6200000">
            <a:off x="4511418" y="3316323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 rot="16200000">
            <a:off x="4584556" y="2144580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6200000">
            <a:off x="4835159" y="3166715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6200000">
            <a:off x="5026457" y="17785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6200000">
            <a:off x="5157354" y="363823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6200000">
            <a:off x="5167499" y="2010623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d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6200000">
            <a:off x="5435386" y="230485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 rot="16200000">
            <a:off x="5663846" y="2918593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f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6200000">
            <a:off x="5718042" y="2289086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d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6200000">
            <a:off x="5968176" y="185529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6200000">
            <a:off x="6139052" y="1681093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6200000">
            <a:off x="6252325" y="205326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 rot="16200000">
            <a:off x="6707558" y="361948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7353324" y="165094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31514" y="5301465"/>
            <a:ext cx="833382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itaake wild type plants exhibit enhanced resistance to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ion lengths measured from Kitaake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1A, 2A, 3A, 4A at 12 DAI and 5A, 7A, 8A, 9A, 10A, 11A, 12A, 13A, 14A, 15A, 16A, 18A, 19A, and 21A at 10 DAI), XA21 transgenic plants (23A-1-14), and Kitaake wild type plants. The error bars represent standard error of at least three leaves from each plant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1337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785393" y="812846"/>
            <a:ext cx="3208665" cy="4472066"/>
            <a:chOff x="863995" y="1019503"/>
            <a:chExt cx="3208665" cy="4472066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3995" y="1019503"/>
              <a:ext cx="3163824" cy="3725115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1078189" y="4923815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t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693913" y="4923815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A21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474995" y="4752365"/>
              <a:ext cx="813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A-42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259617" y="4752365"/>
              <a:ext cx="813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A-38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547852" y="5122237"/>
              <a:ext cx="140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ox/Kit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직선 연결선 14"/>
            <p:cNvCxnSpPr/>
            <p:nvPr/>
          </p:nvCxnSpPr>
          <p:spPr>
            <a:xfrm>
              <a:off x="2575444" y="5120649"/>
              <a:ext cx="133877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TextBox 10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3</a:t>
            </a:r>
            <a:endParaRPr lang="ko-KR" altLang="en-US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452062" y="5454774"/>
            <a:ext cx="828097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taake plants overexpressing XB21 (XB21ox/Kit) display cell death lesions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taake wild type (Kit), transgenic rice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the control of its native promoter (XA21, 23A-1-14), and Kitaake wild type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, 4A-42 and 5A-38) were photographed six-weeks after planting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5487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236063" y="4672961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484923" y="4672961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536909" y="5096570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-752056" y="2688497"/>
            <a:ext cx="1815123" cy="299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3887" y="438253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3887" y="36023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38917" y="282210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38917" y="204189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8917" y="126167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38917" y="48146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26"/>
          <p:cNvCxnSpPr/>
          <p:nvPr/>
        </p:nvCxnSpPr>
        <p:spPr>
          <a:xfrm>
            <a:off x="1137411" y="4784441"/>
            <a:ext cx="150545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1714986" y="481469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26"/>
          <p:cNvCxnSpPr/>
          <p:nvPr/>
        </p:nvCxnSpPr>
        <p:spPr>
          <a:xfrm>
            <a:off x="1194039" y="5086583"/>
            <a:ext cx="6288665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26"/>
          <p:cNvCxnSpPr/>
          <p:nvPr/>
        </p:nvCxnSpPr>
        <p:spPr>
          <a:xfrm>
            <a:off x="2890938" y="4784441"/>
            <a:ext cx="1656002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26"/>
          <p:cNvCxnSpPr/>
          <p:nvPr/>
        </p:nvCxnSpPr>
        <p:spPr>
          <a:xfrm>
            <a:off x="4662662" y="4784441"/>
            <a:ext cx="246154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26"/>
          <p:cNvCxnSpPr/>
          <p:nvPr/>
        </p:nvCxnSpPr>
        <p:spPr>
          <a:xfrm>
            <a:off x="5097444" y="4784441"/>
            <a:ext cx="84979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26"/>
          <p:cNvCxnSpPr/>
          <p:nvPr/>
        </p:nvCxnSpPr>
        <p:spPr>
          <a:xfrm>
            <a:off x="6164244" y="4784441"/>
            <a:ext cx="84979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26"/>
          <p:cNvCxnSpPr/>
          <p:nvPr/>
        </p:nvCxnSpPr>
        <p:spPr>
          <a:xfrm>
            <a:off x="7202662" y="4784441"/>
            <a:ext cx="246154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3569186" y="481469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610586" y="4814691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6375886" y="4814691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B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321786" y="4814691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7099786" y="4814691"/>
            <a:ext cx="4443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A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4</a:t>
            </a:r>
            <a:endParaRPr lang="ko-KR" altLang="en-US" sz="1200" dirty="0"/>
          </a:p>
        </p:txBody>
      </p:sp>
      <p:sp>
        <p:nvSpPr>
          <p:cNvPr id="80" name="TextBox 79"/>
          <p:cNvSpPr txBox="1"/>
          <p:nvPr/>
        </p:nvSpPr>
        <p:spPr>
          <a:xfrm>
            <a:off x="1497388" y="31299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259758" y="151675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4228735" y="82556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5401936" y="109826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6762352" y="140473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7200394" y="113817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8261314" y="110683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821" y="632894"/>
            <a:ext cx="8399058" cy="3934097"/>
          </a:xfrm>
          <a:prstGeom prst="rect">
            <a:avLst/>
          </a:prstGeom>
        </p:spPr>
      </p:pic>
      <p:grpSp>
        <p:nvGrpSpPr>
          <p:cNvPr id="113" name="그룹 112"/>
          <p:cNvGrpSpPr/>
          <p:nvPr/>
        </p:nvGrpSpPr>
        <p:grpSpPr>
          <a:xfrm>
            <a:off x="1153613" y="3380399"/>
            <a:ext cx="899402" cy="49106"/>
            <a:chOff x="5206111" y="592667"/>
            <a:chExt cx="1593343" cy="778991"/>
          </a:xfrm>
        </p:grpSpPr>
        <p:cxnSp>
          <p:nvCxnSpPr>
            <p:cNvPr id="155" name="직선 연결선 15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직선 연결선 15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직선 연결선 156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8" name="그룹 157"/>
          <p:cNvGrpSpPr/>
          <p:nvPr/>
        </p:nvGrpSpPr>
        <p:grpSpPr>
          <a:xfrm>
            <a:off x="2883214" y="3173206"/>
            <a:ext cx="1197104" cy="49106"/>
            <a:chOff x="5206111" y="592667"/>
            <a:chExt cx="1593343" cy="778991"/>
          </a:xfrm>
        </p:grpSpPr>
        <p:cxnSp>
          <p:nvCxnSpPr>
            <p:cNvPr id="159" name="직선 연결선 158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직선 연결선 15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직선 연결선 16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6" name="그룹 165"/>
          <p:cNvGrpSpPr/>
          <p:nvPr/>
        </p:nvGrpSpPr>
        <p:grpSpPr>
          <a:xfrm>
            <a:off x="6152407" y="3192046"/>
            <a:ext cx="614304" cy="49106"/>
            <a:chOff x="5206111" y="592667"/>
            <a:chExt cx="1593343" cy="778991"/>
          </a:xfrm>
        </p:grpSpPr>
        <p:cxnSp>
          <p:nvCxnSpPr>
            <p:cNvPr id="167" name="직선 연결선 166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직선 연결선 167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직선 연결선 168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0" name="그룹 169"/>
          <p:cNvGrpSpPr/>
          <p:nvPr/>
        </p:nvGrpSpPr>
        <p:grpSpPr>
          <a:xfrm>
            <a:off x="7529368" y="3611571"/>
            <a:ext cx="507689" cy="49106"/>
            <a:chOff x="5206111" y="592667"/>
            <a:chExt cx="1593343" cy="778991"/>
          </a:xfrm>
        </p:grpSpPr>
        <p:cxnSp>
          <p:nvCxnSpPr>
            <p:cNvPr id="171" name="직선 연결선 17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직선 연결선 17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직선 연결선 17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4" name="그룹 173"/>
          <p:cNvGrpSpPr/>
          <p:nvPr/>
        </p:nvGrpSpPr>
        <p:grpSpPr>
          <a:xfrm>
            <a:off x="8174927" y="1370087"/>
            <a:ext cx="507689" cy="49106"/>
            <a:chOff x="5206111" y="592667"/>
            <a:chExt cx="1593343" cy="778991"/>
          </a:xfrm>
        </p:grpSpPr>
        <p:cxnSp>
          <p:nvCxnSpPr>
            <p:cNvPr id="175" name="직선 연결선 174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직선 연결선 175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직선 연결선 176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8" name="그룹 177"/>
          <p:cNvGrpSpPr/>
          <p:nvPr/>
        </p:nvGrpSpPr>
        <p:grpSpPr>
          <a:xfrm>
            <a:off x="6769416" y="1656049"/>
            <a:ext cx="315235" cy="49106"/>
            <a:chOff x="5206111" y="592667"/>
            <a:chExt cx="1593343" cy="778991"/>
          </a:xfrm>
        </p:grpSpPr>
        <p:cxnSp>
          <p:nvCxnSpPr>
            <p:cNvPr id="179" name="직선 연결선 178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직선 연결선 179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직선 연결선 180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2" name="그룹 181"/>
          <p:cNvGrpSpPr/>
          <p:nvPr/>
        </p:nvGrpSpPr>
        <p:grpSpPr>
          <a:xfrm>
            <a:off x="5180862" y="1356392"/>
            <a:ext cx="817642" cy="49106"/>
            <a:chOff x="5206111" y="592667"/>
            <a:chExt cx="1593343" cy="778991"/>
          </a:xfrm>
        </p:grpSpPr>
        <p:cxnSp>
          <p:nvCxnSpPr>
            <p:cNvPr id="183" name="직선 연결선 182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직선 연결선 183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직선 연결선 184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6" name="그룹 185"/>
          <p:cNvGrpSpPr/>
          <p:nvPr/>
        </p:nvGrpSpPr>
        <p:grpSpPr>
          <a:xfrm>
            <a:off x="4124307" y="1087550"/>
            <a:ext cx="461537" cy="49106"/>
            <a:chOff x="5206111" y="592667"/>
            <a:chExt cx="1593343" cy="778991"/>
          </a:xfrm>
        </p:grpSpPr>
        <p:cxnSp>
          <p:nvCxnSpPr>
            <p:cNvPr id="187" name="직선 연결선 186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직선 연결선 187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직선 연결선 188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0" name="그룹 189"/>
          <p:cNvGrpSpPr/>
          <p:nvPr/>
        </p:nvGrpSpPr>
        <p:grpSpPr>
          <a:xfrm>
            <a:off x="2083843" y="1774201"/>
            <a:ext cx="614306" cy="49106"/>
            <a:chOff x="5206111" y="592667"/>
            <a:chExt cx="1593343" cy="778991"/>
          </a:xfrm>
        </p:grpSpPr>
        <p:cxnSp>
          <p:nvCxnSpPr>
            <p:cNvPr id="191" name="직선 연결선 190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직선 연결선 191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직선 연결선 192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4" name="TextBox 193"/>
          <p:cNvSpPr txBox="1"/>
          <p:nvPr/>
        </p:nvSpPr>
        <p:spPr>
          <a:xfrm>
            <a:off x="3358307" y="291956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4691737" y="36566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4999403" y="37586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6343602" y="29555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7656978" y="335452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1056721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1996993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1213433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1370145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1526857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1683569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2153705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2310413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1840281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2469505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4039504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2788542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2945565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3101842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3258119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4195781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3414396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3570673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3726950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3883227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4352054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4644469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4961969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5119917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5277865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5435813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5593761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5751707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6701759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6070271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6859632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6228143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6386015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6543887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7174309" y="45254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33887" y="5476123"/>
            <a:ext cx="824787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4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 of XB21ox/Kit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display enhanced resistance to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ion lengths measured 10 days after inoculation from Kitaake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progeny from 4A, 5A, 7A, 10A, 10B, and 15A), XA21 transgenic plants (23A-1-14), and Kitaake wild type plants. Progeny not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 construct are labeled with a white bar. The error bars represent standard error of at least three leaves from each plant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56032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71409" y="2268495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ko-KR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362537" y="2502166"/>
            <a:ext cx="469987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994138" y="2502166"/>
            <a:ext cx="469987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538006" y="2502166"/>
            <a:ext cx="469987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81876" y="2502166"/>
            <a:ext cx="469987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06405" y="2502166"/>
            <a:ext cx="469987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50272" y="2502166"/>
            <a:ext cx="469987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26"/>
          <p:cNvCxnSpPr/>
          <p:nvPr/>
        </p:nvCxnSpPr>
        <p:spPr>
          <a:xfrm>
            <a:off x="3481589" y="2493229"/>
            <a:ext cx="1260340" cy="194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26"/>
          <p:cNvCxnSpPr/>
          <p:nvPr/>
        </p:nvCxnSpPr>
        <p:spPr>
          <a:xfrm>
            <a:off x="4985064" y="2493229"/>
            <a:ext cx="401583" cy="194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26"/>
          <p:cNvCxnSpPr/>
          <p:nvPr/>
        </p:nvCxnSpPr>
        <p:spPr>
          <a:xfrm>
            <a:off x="5639607" y="2493229"/>
            <a:ext cx="711428" cy="194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76765" y="2166764"/>
            <a:ext cx="507320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991177" y="2166764"/>
            <a:ext cx="507320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754333" y="2166764"/>
            <a:ext cx="629139" cy="377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B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26"/>
          <p:cNvCxnSpPr/>
          <p:nvPr/>
        </p:nvCxnSpPr>
        <p:spPr>
          <a:xfrm>
            <a:off x="3696179" y="2138067"/>
            <a:ext cx="2456048" cy="194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301340" y="1738762"/>
            <a:ext cx="12666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Kit</a:t>
            </a:r>
            <a:endParaRPr lang="ko-KR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102377" y="321258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XB21</a:t>
            </a:r>
            <a:endParaRPr lang="ko-KR" altLang="en-US" sz="14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22465" y="3822745"/>
            <a:ext cx="1013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18S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RNA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1956" y="3691102"/>
            <a:ext cx="3877762" cy="638902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2504" y="3008929"/>
            <a:ext cx="3876665" cy="642195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1893987" y="2727027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</a:t>
            </a:r>
            <a:endParaRPr lang="ko-KR" altLang="en-US" sz="14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905246" y="2727027"/>
            <a:ext cx="3518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+-++-+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5</a:t>
            </a:r>
            <a:endParaRPr lang="ko-KR" alt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441789" y="5085709"/>
            <a:ext cx="829124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5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genic Kitaake plants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(XB21ox/Kit) overexpress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RNA was extracted from four week old stage of 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(progeny from 4A, 5A, and 10B) and Kit wild type plants, and RT-PCR was performed with specific primers for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geny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was labelled with ‘+’ and non-transgenic segregants was labelled with ‘-’. Control RT-PCR reaction was carried out with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S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N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perimental results were repeated twice, with similar results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87636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495656" y="2619174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82364" y="469309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82364" y="421757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82364" y="374206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82364" y="326654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82364" y="279102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73441" y="23155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73441" y="183998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73441" y="136447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73441" y="8889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73441" y="41343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894985" y="277582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317820" y="309958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482764" y="33497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625563" y="762405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060262" y="1246647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6</a:t>
            </a:r>
            <a:endParaRPr lang="ko-KR" altLang="en-US" sz="12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r="49497"/>
          <a:stretch/>
        </p:blipFill>
        <p:spPr>
          <a:xfrm>
            <a:off x="2103544" y="565094"/>
            <a:ext cx="5047269" cy="4304056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2634858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347803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807298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530520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990016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166896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677425" y="48818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860329" y="48818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601944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780632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241267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965621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145445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431417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320160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499980" y="4881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868691" y="4988262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278250" y="4988263"/>
            <a:ext cx="7550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Straight Connector 23"/>
          <p:cNvCxnSpPr/>
          <p:nvPr/>
        </p:nvCxnSpPr>
        <p:spPr>
          <a:xfrm>
            <a:off x="5907988" y="4976348"/>
            <a:ext cx="33896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23"/>
          <p:cNvCxnSpPr/>
          <p:nvPr/>
        </p:nvCxnSpPr>
        <p:spPr>
          <a:xfrm>
            <a:off x="6429821" y="4978275"/>
            <a:ext cx="37285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23"/>
          <p:cNvCxnSpPr/>
          <p:nvPr/>
        </p:nvCxnSpPr>
        <p:spPr>
          <a:xfrm>
            <a:off x="2670429" y="5123853"/>
            <a:ext cx="141591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23"/>
          <p:cNvCxnSpPr/>
          <p:nvPr/>
        </p:nvCxnSpPr>
        <p:spPr>
          <a:xfrm>
            <a:off x="4290117" y="5123853"/>
            <a:ext cx="141591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3561856" y="5385451"/>
            <a:ext cx="1347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102753" y="5112070"/>
            <a:ext cx="5850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A-7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675631" y="5112070"/>
            <a:ext cx="678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A-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23"/>
          <p:cNvCxnSpPr/>
          <p:nvPr/>
        </p:nvCxnSpPr>
        <p:spPr>
          <a:xfrm>
            <a:off x="3055626" y="5377853"/>
            <a:ext cx="228035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7" name="그룹 116"/>
          <p:cNvGrpSpPr/>
          <p:nvPr/>
        </p:nvGrpSpPr>
        <p:grpSpPr>
          <a:xfrm>
            <a:off x="2678365" y="3028806"/>
            <a:ext cx="675734" cy="49106"/>
            <a:chOff x="5206111" y="592667"/>
            <a:chExt cx="1593343" cy="778991"/>
          </a:xfrm>
        </p:grpSpPr>
        <p:cxnSp>
          <p:nvCxnSpPr>
            <p:cNvPr id="118" name="직선 연결선 11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직선 연결선 11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연결선 11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그룹 120"/>
          <p:cNvGrpSpPr/>
          <p:nvPr/>
        </p:nvGrpSpPr>
        <p:grpSpPr>
          <a:xfrm>
            <a:off x="4295280" y="3355869"/>
            <a:ext cx="315235" cy="49106"/>
            <a:chOff x="5206111" y="592667"/>
            <a:chExt cx="1593343" cy="778991"/>
          </a:xfrm>
        </p:grpSpPr>
        <p:cxnSp>
          <p:nvCxnSpPr>
            <p:cNvPr id="122" name="직선 연결선 121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직선 연결선 122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직선 연결선 123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5" name="그룹 124"/>
          <p:cNvGrpSpPr/>
          <p:nvPr/>
        </p:nvGrpSpPr>
        <p:grpSpPr>
          <a:xfrm>
            <a:off x="6442628" y="3590463"/>
            <a:ext cx="315235" cy="49106"/>
            <a:chOff x="5206111" y="592667"/>
            <a:chExt cx="1593343" cy="778991"/>
          </a:xfrm>
        </p:grpSpPr>
        <p:cxnSp>
          <p:nvCxnSpPr>
            <p:cNvPr id="126" name="직선 연결선 125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직선 연결선 126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직선 연결선 127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그룹 128"/>
          <p:cNvGrpSpPr/>
          <p:nvPr/>
        </p:nvGrpSpPr>
        <p:grpSpPr>
          <a:xfrm>
            <a:off x="5899134" y="1513558"/>
            <a:ext cx="315235" cy="49106"/>
            <a:chOff x="5206111" y="592667"/>
            <a:chExt cx="1593343" cy="778991"/>
          </a:xfrm>
        </p:grpSpPr>
        <p:cxnSp>
          <p:nvCxnSpPr>
            <p:cNvPr id="130" name="직선 연결선 129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직선 연결선 130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직선 연결선 131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3" name="그룹 132"/>
          <p:cNvGrpSpPr/>
          <p:nvPr/>
        </p:nvGrpSpPr>
        <p:grpSpPr>
          <a:xfrm>
            <a:off x="3404884" y="1013625"/>
            <a:ext cx="675734" cy="49106"/>
            <a:chOff x="5206111" y="592667"/>
            <a:chExt cx="1593343" cy="778991"/>
          </a:xfrm>
        </p:grpSpPr>
        <p:cxnSp>
          <p:nvCxnSpPr>
            <p:cNvPr id="134" name="직선 연결선 133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직선 연결선 134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직선 연결선 135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7" name="그룹 136"/>
          <p:cNvGrpSpPr/>
          <p:nvPr/>
        </p:nvGrpSpPr>
        <p:grpSpPr>
          <a:xfrm>
            <a:off x="4614732" y="1505071"/>
            <a:ext cx="1088276" cy="49106"/>
            <a:chOff x="5206111" y="592667"/>
            <a:chExt cx="1593343" cy="778991"/>
          </a:xfrm>
        </p:grpSpPr>
        <p:cxnSp>
          <p:nvCxnSpPr>
            <p:cNvPr id="138" name="직선 연결선 13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직선 연결선 13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직선 연결선 13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1" name="TextBox 140"/>
          <p:cNvSpPr txBox="1"/>
          <p:nvPr/>
        </p:nvSpPr>
        <p:spPr>
          <a:xfrm>
            <a:off x="5931850" y="1265484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1789" y="5794628"/>
            <a:ext cx="828097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6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itaake wild type plants (XB21ox/Kit,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splays resistant to a virulent strai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taake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, progeny from 5A-4, 5A-7, 10A-1, and 10A-3), Kitaake wild type (Kit), and transgenic rice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the control of its native promoter (XA21, 23A-1-14) were inoculated with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esion lengths of each plant were measured 12 days after inoculation. The error bars represent standard error of two to five leaves from each plant. Gray bar, progeny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in XB21ox/Kit plants; White bar, progeny not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2306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495656" y="2372602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Lesion length (cm)</a:t>
            </a:r>
            <a:endParaRPr lang="ko-KR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82364" y="408692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82364" y="368218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82364" y="327744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82364" y="28727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82364" y="246796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73441" y="20632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73441" y="16584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73441" y="125374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73441" y="84899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73441" y="44425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894985" y="24778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317820" y="27091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482764" y="29387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625563" y="659665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060262" y="1123359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6</a:t>
            </a:r>
            <a:endParaRPr lang="ko-KR" altLang="en-US" sz="12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r="49497"/>
          <a:stretch/>
        </p:blipFill>
        <p:spPr>
          <a:xfrm>
            <a:off x="2103544" y="598964"/>
            <a:ext cx="5047269" cy="3664019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2634858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347803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807298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530520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990016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166896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677425" y="42757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860329" y="42757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601944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780632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241267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965621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145445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431417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320160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499980" y="42757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868691" y="4382096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i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278250" y="4382097"/>
            <a:ext cx="7550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A2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Straight Connector 23"/>
          <p:cNvCxnSpPr/>
          <p:nvPr/>
        </p:nvCxnSpPr>
        <p:spPr>
          <a:xfrm>
            <a:off x="5907988" y="4370182"/>
            <a:ext cx="33896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23"/>
          <p:cNvCxnSpPr/>
          <p:nvPr/>
        </p:nvCxnSpPr>
        <p:spPr>
          <a:xfrm>
            <a:off x="6429821" y="4372109"/>
            <a:ext cx="37285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23"/>
          <p:cNvCxnSpPr/>
          <p:nvPr/>
        </p:nvCxnSpPr>
        <p:spPr>
          <a:xfrm>
            <a:off x="2670429" y="4517687"/>
            <a:ext cx="141591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23"/>
          <p:cNvCxnSpPr/>
          <p:nvPr/>
        </p:nvCxnSpPr>
        <p:spPr>
          <a:xfrm>
            <a:off x="4290117" y="4517687"/>
            <a:ext cx="141591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3561856" y="4779285"/>
            <a:ext cx="1347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21ox/Kit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102753" y="4505904"/>
            <a:ext cx="5850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A-7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675631" y="4505904"/>
            <a:ext cx="678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A-1</a:t>
            </a:r>
            <a:endParaRPr lang="ko-KR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23"/>
          <p:cNvCxnSpPr/>
          <p:nvPr/>
        </p:nvCxnSpPr>
        <p:spPr>
          <a:xfrm>
            <a:off x="3055626" y="4771687"/>
            <a:ext cx="228035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7" name="그룹 116"/>
          <p:cNvGrpSpPr/>
          <p:nvPr/>
        </p:nvGrpSpPr>
        <p:grpSpPr>
          <a:xfrm>
            <a:off x="2678365" y="2730860"/>
            <a:ext cx="675734" cy="49106"/>
            <a:chOff x="5206111" y="592667"/>
            <a:chExt cx="1593343" cy="778991"/>
          </a:xfrm>
        </p:grpSpPr>
        <p:cxnSp>
          <p:nvCxnSpPr>
            <p:cNvPr id="118" name="직선 연결선 11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직선 연결선 11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연결선 11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그룹 120"/>
          <p:cNvGrpSpPr/>
          <p:nvPr/>
        </p:nvGrpSpPr>
        <p:grpSpPr>
          <a:xfrm>
            <a:off x="4295280" y="2965457"/>
            <a:ext cx="315235" cy="49106"/>
            <a:chOff x="5206111" y="592667"/>
            <a:chExt cx="1593343" cy="778991"/>
          </a:xfrm>
        </p:grpSpPr>
        <p:cxnSp>
          <p:nvCxnSpPr>
            <p:cNvPr id="122" name="직선 연결선 121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직선 연결선 122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직선 연결선 123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5" name="그룹 124"/>
          <p:cNvGrpSpPr/>
          <p:nvPr/>
        </p:nvGrpSpPr>
        <p:grpSpPr>
          <a:xfrm>
            <a:off x="6442628" y="3179503"/>
            <a:ext cx="315235" cy="49106"/>
            <a:chOff x="5206111" y="592667"/>
            <a:chExt cx="1593343" cy="778991"/>
          </a:xfrm>
        </p:grpSpPr>
        <p:cxnSp>
          <p:nvCxnSpPr>
            <p:cNvPr id="126" name="직선 연결선 125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직선 연결선 126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직선 연결선 127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그룹 128"/>
          <p:cNvGrpSpPr/>
          <p:nvPr/>
        </p:nvGrpSpPr>
        <p:grpSpPr>
          <a:xfrm>
            <a:off x="5899134" y="1390270"/>
            <a:ext cx="315235" cy="49106"/>
            <a:chOff x="5206111" y="592667"/>
            <a:chExt cx="1593343" cy="778991"/>
          </a:xfrm>
        </p:grpSpPr>
        <p:cxnSp>
          <p:nvCxnSpPr>
            <p:cNvPr id="130" name="직선 연결선 129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직선 연결선 130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직선 연결선 131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3" name="그룹 132"/>
          <p:cNvGrpSpPr/>
          <p:nvPr/>
        </p:nvGrpSpPr>
        <p:grpSpPr>
          <a:xfrm>
            <a:off x="3404884" y="910885"/>
            <a:ext cx="675734" cy="49106"/>
            <a:chOff x="5206111" y="592667"/>
            <a:chExt cx="1593343" cy="778991"/>
          </a:xfrm>
        </p:grpSpPr>
        <p:cxnSp>
          <p:nvCxnSpPr>
            <p:cNvPr id="134" name="직선 연결선 133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직선 연결선 134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직선 연결선 135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7" name="그룹 136"/>
          <p:cNvGrpSpPr/>
          <p:nvPr/>
        </p:nvGrpSpPr>
        <p:grpSpPr>
          <a:xfrm>
            <a:off x="4614732" y="1381783"/>
            <a:ext cx="1088276" cy="49106"/>
            <a:chOff x="5206111" y="592667"/>
            <a:chExt cx="1593343" cy="778991"/>
          </a:xfrm>
        </p:grpSpPr>
        <p:cxnSp>
          <p:nvCxnSpPr>
            <p:cNvPr id="138" name="직선 연결선 137"/>
            <p:cNvCxnSpPr/>
            <p:nvPr/>
          </p:nvCxnSpPr>
          <p:spPr>
            <a:xfrm>
              <a:off x="5206111" y="973667"/>
              <a:ext cx="15906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직선 연결선 138"/>
            <p:cNvCxnSpPr/>
            <p:nvPr/>
          </p:nvCxnSpPr>
          <p:spPr>
            <a:xfrm>
              <a:off x="5207718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직선 연결선 139"/>
            <p:cNvCxnSpPr/>
            <p:nvPr/>
          </p:nvCxnSpPr>
          <p:spPr>
            <a:xfrm>
              <a:off x="6799454" y="592667"/>
              <a:ext cx="0" cy="7789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1" name="TextBox 140"/>
          <p:cNvSpPr txBox="1"/>
          <p:nvPr/>
        </p:nvSpPr>
        <p:spPr>
          <a:xfrm>
            <a:off x="5931850" y="1142196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1789" y="5137082"/>
            <a:ext cx="828097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6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itaake wild type plants (XB21ox/Kit,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splays resistant to a virulent strai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taake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, progeny from 5A-4, 5A-7, 10A-1, and 10A-3), Kitaake wild type (Kit), and transgenic rice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the control of its native promoter (XA21, 23A-1-14) were inoculated with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o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esion lengths of each plant were measured 12 days after inoculation. The error bars represent standard error of two to five leaves from each plant. Gray bar, progeny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 in XB21ox/Kit plants; White bar, progeny not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ox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11755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2503021" y="1077377"/>
            <a:ext cx="3974592" cy="4472065"/>
            <a:chOff x="4922773" y="1019503"/>
            <a:chExt cx="3974592" cy="4472065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2773" y="1019503"/>
              <a:ext cx="3974592" cy="373605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5124174" y="4923814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t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739898" y="4923814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A21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562449" y="4752364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A-2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333974" y="4752364"/>
              <a:ext cx="8002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A-11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210274" y="4752364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A-2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907068" y="5122236"/>
              <a:ext cx="16722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B21ox/XA21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직선 연결선 14"/>
            <p:cNvCxnSpPr/>
            <p:nvPr/>
          </p:nvCxnSpPr>
          <p:spPr>
            <a:xfrm>
              <a:off x="6712693" y="5120648"/>
              <a:ext cx="1960098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/>
          <p:cNvSpPr txBox="1"/>
          <p:nvPr/>
        </p:nvSpPr>
        <p:spPr>
          <a:xfrm>
            <a:off x="-974" y="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Fig. S7</a:t>
            </a:r>
            <a:endParaRPr lang="ko-KR" alt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441789" y="5763804"/>
            <a:ext cx="828097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7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XA21 plants (XB21ox/XA21) displays cell death lesions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taake wild type (Kit), transgenic rice carry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the control of its native promoter (XA21, 23A-1-14), and XA21 plants overexpressing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2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B21ox/Kit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, 2A-2, 3A-11, and 5A-2) were photographed at six-week stage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2483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000</TotalTime>
  <Words>1782</Words>
  <Application>Microsoft Office PowerPoint</Application>
  <PresentationFormat>화면 슬라이드 쇼(4:3)</PresentationFormat>
  <Paragraphs>562</Paragraphs>
  <Slides>1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21" baseType="lpstr">
      <vt:lpstr>맑은 고딕</vt:lpstr>
      <vt:lpstr>Arial</vt:lpstr>
      <vt:lpstr>Calibri</vt:lpstr>
      <vt:lpstr>Calibri Light</vt:lpstr>
      <vt:lpstr>Times New Roman</vt:lpstr>
      <vt:lpstr>Office 테마</vt:lpstr>
      <vt:lpstr>SPW 11.0 Graph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창진</dc:creator>
  <cp:lastModifiedBy>CJ Park</cp:lastModifiedBy>
  <cp:revision>374</cp:revision>
  <cp:lastPrinted>2017-05-19T05:21:28Z</cp:lastPrinted>
  <dcterms:created xsi:type="dcterms:W3CDTF">2014-01-08T09:49:08Z</dcterms:created>
  <dcterms:modified xsi:type="dcterms:W3CDTF">2017-05-29T06:27:43Z</dcterms:modified>
</cp:coreProperties>
</file>